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16"/>
  </p:notesMasterIdLst>
  <p:sldIdLst>
    <p:sldId id="269" r:id="rId2"/>
    <p:sldId id="256" r:id="rId3"/>
    <p:sldId id="268" r:id="rId4"/>
    <p:sldId id="267" r:id="rId5"/>
    <p:sldId id="266" r:id="rId6"/>
    <p:sldId id="265" r:id="rId7"/>
    <p:sldId id="264" r:id="rId8"/>
    <p:sldId id="263" r:id="rId9"/>
    <p:sldId id="262" r:id="rId10"/>
    <p:sldId id="258" r:id="rId11"/>
    <p:sldId id="261" r:id="rId12"/>
    <p:sldId id="260" r:id="rId13"/>
    <p:sldId id="259" r:id="rId14"/>
    <p:sldId id="257" r:id="rId15"/>
  </p:sldIdLst>
  <p:sldSz cx="9906000" cy="6858000" type="A4"/>
  <p:notesSz cx="9926638" cy="67976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6F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5" d="100"/>
          <a:sy n="105" d="100"/>
        </p:scale>
        <p:origin x="1548" y="96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21" Type="http://schemas.microsoft.com/office/2016/11/relationships/changesInfo" Target="changesInfos/changesInfo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notesMaster" Target="notesMasters/notesMaster1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LESSANDRA VILLANI" userId="133fede2-0572-40fa-bbbe-28bfc0bba9e3" providerId="ADAL" clId="{3D250BF1-7618-4C11-B8D4-EDCD5AD05631}"/>
    <pc:docChg chg="modSld">
      <pc:chgData name="ALESSANDRA VILLANI" userId="133fede2-0572-40fa-bbbe-28bfc0bba9e3" providerId="ADAL" clId="{3D250BF1-7618-4C11-B8D4-EDCD5AD05631}" dt="2025-12-11T21:31:28.349" v="4" actId="114"/>
      <pc:docMkLst>
        <pc:docMk/>
      </pc:docMkLst>
      <pc:sldChg chg="modSp mod">
        <pc:chgData name="ALESSANDRA VILLANI" userId="133fede2-0572-40fa-bbbe-28bfc0bba9e3" providerId="ADAL" clId="{3D250BF1-7618-4C11-B8D4-EDCD5AD05631}" dt="2025-12-11T21:31:28.349" v="4" actId="114"/>
        <pc:sldMkLst>
          <pc:docMk/>
          <pc:sldMk cId="938895209" sldId="265"/>
        </pc:sldMkLst>
        <pc:spChg chg="mod">
          <ac:chgData name="ALESSANDRA VILLANI" userId="133fede2-0572-40fa-bbbe-28bfc0bba9e3" providerId="ADAL" clId="{3D250BF1-7618-4C11-B8D4-EDCD5AD05631}" dt="2025-12-11T21:31:28.349" v="4" actId="114"/>
          <ac:spMkLst>
            <pc:docMk/>
            <pc:sldMk cId="938895209" sldId="265"/>
            <ac:spMk id="4" creationId="{A54AB530-3726-2A0B-9B9B-DC4350742947}"/>
          </ac:spMkLst>
        </pc:spChg>
      </pc:sldChg>
      <pc:sldChg chg="modSp mod">
        <pc:chgData name="ALESSANDRA VILLANI" userId="133fede2-0572-40fa-bbbe-28bfc0bba9e3" providerId="ADAL" clId="{3D250BF1-7618-4C11-B8D4-EDCD5AD05631}" dt="2025-12-11T21:31:13.857" v="3" actId="1076"/>
        <pc:sldMkLst>
          <pc:docMk/>
          <pc:sldMk cId="3368783863" sldId="268"/>
        </pc:sldMkLst>
        <pc:spChg chg="mod">
          <ac:chgData name="ALESSANDRA VILLANI" userId="133fede2-0572-40fa-bbbe-28bfc0bba9e3" providerId="ADAL" clId="{3D250BF1-7618-4C11-B8D4-EDCD5AD05631}" dt="2025-12-11T21:31:13.857" v="3" actId="1076"/>
          <ac:spMkLst>
            <pc:docMk/>
            <pc:sldMk cId="3368783863" sldId="268"/>
            <ac:spMk id="8" creationId="{461DA178-B086-7CEE-2A26-B1FEE6AF1D08}"/>
          </ac:spMkLst>
        </pc:spChg>
      </pc:sldChg>
      <pc:sldChg chg="addSp modSp mod">
        <pc:chgData name="ALESSANDRA VILLANI" userId="133fede2-0572-40fa-bbbe-28bfc0bba9e3" providerId="ADAL" clId="{3D250BF1-7618-4C11-B8D4-EDCD5AD05631}" dt="2025-12-10T13:48:48.691" v="2" actId="20577"/>
        <pc:sldMkLst>
          <pc:docMk/>
          <pc:sldMk cId="2428146435" sldId="269"/>
        </pc:sldMkLst>
        <pc:spChg chg="add mod">
          <ac:chgData name="ALESSANDRA VILLANI" userId="133fede2-0572-40fa-bbbe-28bfc0bba9e3" providerId="ADAL" clId="{3D250BF1-7618-4C11-B8D4-EDCD5AD05631}" dt="2025-12-10T13:48:48.691" v="2" actId="20577"/>
          <ac:spMkLst>
            <pc:docMk/>
            <pc:sldMk cId="2428146435" sldId="269"/>
            <ac:spMk id="3" creationId="{8C2495D3-2AF1-46A5-D833-8AB23351AFE8}"/>
          </ac:spMkLst>
        </pc:spChg>
      </pc:sldChg>
    </pc:docChg>
  </pc:docChgLst>
  <pc:docChgLst>
    <pc:chgData name="VERONICA GHIONNA" userId="df799423-6250-4717-b524-c1ee7c82214c" providerId="ADAL" clId="{2FC1D459-4C4C-4050-BB87-A8E340603A11}"/>
    <pc:docChg chg="undo custSel addSld modSld sldOrd">
      <pc:chgData name="VERONICA GHIONNA" userId="df799423-6250-4717-b524-c1ee7c82214c" providerId="ADAL" clId="{2FC1D459-4C4C-4050-BB87-A8E340603A11}" dt="2025-12-10T14:06:21.591" v="425" actId="114"/>
      <pc:docMkLst>
        <pc:docMk/>
      </pc:docMkLst>
      <pc:sldChg chg="modSp mod">
        <pc:chgData name="VERONICA GHIONNA" userId="df799423-6250-4717-b524-c1ee7c82214c" providerId="ADAL" clId="{2FC1D459-4C4C-4050-BB87-A8E340603A11}" dt="2025-12-10T14:04:49.094" v="417" actId="14100"/>
        <pc:sldMkLst>
          <pc:docMk/>
          <pc:sldMk cId="568988168" sldId="256"/>
        </pc:sldMkLst>
        <pc:grpChg chg="mod">
          <ac:chgData name="VERONICA GHIONNA" userId="df799423-6250-4717-b524-c1ee7c82214c" providerId="ADAL" clId="{2FC1D459-4C4C-4050-BB87-A8E340603A11}" dt="2025-12-10T14:04:49.094" v="417" actId="14100"/>
          <ac:grpSpMkLst>
            <pc:docMk/>
            <pc:sldMk cId="568988168" sldId="256"/>
            <ac:grpSpMk id="38" creationId="{F6EC2A27-CC65-42F8-937E-CE7D1FDE6DE5}"/>
          </ac:grpSpMkLst>
        </pc:grpChg>
      </pc:sldChg>
      <pc:sldChg chg="modSp mod">
        <pc:chgData name="VERONICA GHIONNA" userId="df799423-6250-4717-b524-c1ee7c82214c" providerId="ADAL" clId="{2FC1D459-4C4C-4050-BB87-A8E340603A11}" dt="2025-12-10T14:04:34.334" v="415" actId="114"/>
        <pc:sldMkLst>
          <pc:docMk/>
          <pc:sldMk cId="436974634" sldId="257"/>
        </pc:sldMkLst>
        <pc:spChg chg="mod">
          <ac:chgData name="VERONICA GHIONNA" userId="df799423-6250-4717-b524-c1ee7c82214c" providerId="ADAL" clId="{2FC1D459-4C4C-4050-BB87-A8E340603A11}" dt="2025-12-10T14:04:34.334" v="415" actId="114"/>
          <ac:spMkLst>
            <pc:docMk/>
            <pc:sldMk cId="436974634" sldId="257"/>
            <ac:spMk id="7" creationId="{46D7B9C7-7F46-1F37-5272-6D28294CC58B}"/>
          </ac:spMkLst>
        </pc:spChg>
      </pc:sldChg>
      <pc:sldChg chg="modSp mod">
        <pc:chgData name="VERONICA GHIONNA" userId="df799423-6250-4717-b524-c1ee7c82214c" providerId="ADAL" clId="{2FC1D459-4C4C-4050-BB87-A8E340603A11}" dt="2025-12-10T14:03:10.701" v="381" actId="114"/>
        <pc:sldMkLst>
          <pc:docMk/>
          <pc:sldMk cId="2663893806" sldId="258"/>
        </pc:sldMkLst>
        <pc:spChg chg="mod">
          <ac:chgData name="VERONICA GHIONNA" userId="df799423-6250-4717-b524-c1ee7c82214c" providerId="ADAL" clId="{2FC1D459-4C4C-4050-BB87-A8E340603A11}" dt="2025-12-10T14:03:10.701" v="381" actId="114"/>
          <ac:spMkLst>
            <pc:docMk/>
            <pc:sldMk cId="2663893806" sldId="258"/>
            <ac:spMk id="6" creationId="{2693F5BC-D98E-433F-BD98-2BF5726EB774}"/>
          </ac:spMkLst>
        </pc:spChg>
      </pc:sldChg>
      <pc:sldChg chg="modSp mod">
        <pc:chgData name="VERONICA GHIONNA" userId="df799423-6250-4717-b524-c1ee7c82214c" providerId="ADAL" clId="{2FC1D459-4C4C-4050-BB87-A8E340603A11}" dt="2025-12-10T14:04:17.318" v="409" actId="114"/>
        <pc:sldMkLst>
          <pc:docMk/>
          <pc:sldMk cId="2055626053" sldId="259"/>
        </pc:sldMkLst>
        <pc:spChg chg="mod">
          <ac:chgData name="VERONICA GHIONNA" userId="df799423-6250-4717-b524-c1ee7c82214c" providerId="ADAL" clId="{2FC1D459-4C4C-4050-BB87-A8E340603A11}" dt="2025-12-10T14:04:17.318" v="409" actId="114"/>
          <ac:spMkLst>
            <pc:docMk/>
            <pc:sldMk cId="2055626053" sldId="259"/>
            <ac:spMk id="6" creationId="{08F7E8FC-0528-D469-1246-C4DB2FDDA888}"/>
          </ac:spMkLst>
        </pc:spChg>
      </pc:sldChg>
      <pc:sldChg chg="modSp mod">
        <pc:chgData name="VERONICA GHIONNA" userId="df799423-6250-4717-b524-c1ee7c82214c" providerId="ADAL" clId="{2FC1D459-4C4C-4050-BB87-A8E340603A11}" dt="2025-12-10T14:04:08.054" v="403" actId="114"/>
        <pc:sldMkLst>
          <pc:docMk/>
          <pc:sldMk cId="4062222991" sldId="260"/>
        </pc:sldMkLst>
        <pc:spChg chg="mod">
          <ac:chgData name="VERONICA GHIONNA" userId="df799423-6250-4717-b524-c1ee7c82214c" providerId="ADAL" clId="{2FC1D459-4C4C-4050-BB87-A8E340603A11}" dt="2025-12-10T14:04:08.054" v="403" actId="114"/>
          <ac:spMkLst>
            <pc:docMk/>
            <pc:sldMk cId="4062222991" sldId="260"/>
            <ac:spMk id="6" creationId="{15EEF25D-4E50-BDB9-35E4-8ED419246DF2}"/>
          </ac:spMkLst>
        </pc:spChg>
      </pc:sldChg>
      <pc:sldChg chg="modSp mod">
        <pc:chgData name="VERONICA GHIONNA" userId="df799423-6250-4717-b524-c1ee7c82214c" providerId="ADAL" clId="{2FC1D459-4C4C-4050-BB87-A8E340603A11}" dt="2025-12-10T14:03:47.053" v="397" actId="114"/>
        <pc:sldMkLst>
          <pc:docMk/>
          <pc:sldMk cId="977854208" sldId="261"/>
        </pc:sldMkLst>
        <pc:spChg chg="mod">
          <ac:chgData name="VERONICA GHIONNA" userId="df799423-6250-4717-b524-c1ee7c82214c" providerId="ADAL" clId="{2FC1D459-4C4C-4050-BB87-A8E340603A11}" dt="2025-12-10T14:03:39.030" v="396" actId="114"/>
          <ac:spMkLst>
            <pc:docMk/>
            <pc:sldMk cId="977854208" sldId="261"/>
            <ac:spMk id="5" creationId="{2A4D1599-7293-346A-4B4C-BEF34AAD6B8D}"/>
          </ac:spMkLst>
        </pc:spChg>
        <pc:spChg chg="mod">
          <ac:chgData name="VERONICA GHIONNA" userId="df799423-6250-4717-b524-c1ee7c82214c" providerId="ADAL" clId="{2FC1D459-4C4C-4050-BB87-A8E340603A11}" dt="2025-12-10T14:03:47.053" v="397" actId="114"/>
          <ac:spMkLst>
            <pc:docMk/>
            <pc:sldMk cId="977854208" sldId="261"/>
            <ac:spMk id="6" creationId="{6642CDF7-EFDB-1559-1136-36DA03026C3C}"/>
          </ac:spMkLst>
        </pc:spChg>
        <pc:spChg chg="mod">
          <ac:chgData name="VERONICA GHIONNA" userId="df799423-6250-4717-b524-c1ee7c82214c" providerId="ADAL" clId="{2FC1D459-4C4C-4050-BB87-A8E340603A11}" dt="2025-12-10T14:03:47.053" v="397" actId="114"/>
          <ac:spMkLst>
            <pc:docMk/>
            <pc:sldMk cId="977854208" sldId="261"/>
            <ac:spMk id="7" creationId="{62C77BEA-40FD-3342-A421-2EC7470D7222}"/>
          </ac:spMkLst>
        </pc:spChg>
        <pc:spChg chg="mod">
          <ac:chgData name="VERONICA GHIONNA" userId="df799423-6250-4717-b524-c1ee7c82214c" providerId="ADAL" clId="{2FC1D459-4C4C-4050-BB87-A8E340603A11}" dt="2025-12-10T14:03:47.053" v="397" actId="114"/>
          <ac:spMkLst>
            <pc:docMk/>
            <pc:sldMk cId="977854208" sldId="261"/>
            <ac:spMk id="8" creationId="{34D09DC0-CCC3-FD43-A020-2B5BE60309D0}"/>
          </ac:spMkLst>
        </pc:spChg>
        <pc:spChg chg="mod">
          <ac:chgData name="VERONICA GHIONNA" userId="df799423-6250-4717-b524-c1ee7c82214c" providerId="ADAL" clId="{2FC1D459-4C4C-4050-BB87-A8E340603A11}" dt="2025-12-10T14:03:47.053" v="397" actId="114"/>
          <ac:spMkLst>
            <pc:docMk/>
            <pc:sldMk cId="977854208" sldId="261"/>
            <ac:spMk id="9" creationId="{7EB583D1-125C-428F-BAF2-F52799C8D6CF}"/>
          </ac:spMkLst>
        </pc:spChg>
        <pc:spChg chg="mod">
          <ac:chgData name="VERONICA GHIONNA" userId="df799423-6250-4717-b524-c1ee7c82214c" providerId="ADAL" clId="{2FC1D459-4C4C-4050-BB87-A8E340603A11}" dt="2025-12-10T14:03:47.053" v="397" actId="114"/>
          <ac:spMkLst>
            <pc:docMk/>
            <pc:sldMk cId="977854208" sldId="261"/>
            <ac:spMk id="11" creationId="{09BD9CF5-103E-02A3-94DA-9AAB2B82ABFC}"/>
          </ac:spMkLst>
        </pc:spChg>
      </pc:sldChg>
      <pc:sldChg chg="modSp mod">
        <pc:chgData name="VERONICA GHIONNA" userId="df799423-6250-4717-b524-c1ee7c82214c" providerId="ADAL" clId="{2FC1D459-4C4C-4050-BB87-A8E340603A11}" dt="2025-12-10T14:02:56.270" v="373" actId="114"/>
        <pc:sldMkLst>
          <pc:docMk/>
          <pc:sldMk cId="3194676812" sldId="262"/>
        </pc:sldMkLst>
        <pc:spChg chg="mod">
          <ac:chgData name="VERONICA GHIONNA" userId="df799423-6250-4717-b524-c1ee7c82214c" providerId="ADAL" clId="{2FC1D459-4C4C-4050-BB87-A8E340603A11}" dt="2025-12-10T14:02:56.270" v="373" actId="114"/>
          <ac:spMkLst>
            <pc:docMk/>
            <pc:sldMk cId="3194676812" sldId="262"/>
            <ac:spMk id="6" creationId="{6CE2C82F-2B93-7458-F246-85148C701DED}"/>
          </ac:spMkLst>
        </pc:spChg>
      </pc:sldChg>
      <pc:sldChg chg="modSp mod">
        <pc:chgData name="VERONICA GHIONNA" userId="df799423-6250-4717-b524-c1ee7c82214c" providerId="ADAL" clId="{2FC1D459-4C4C-4050-BB87-A8E340603A11}" dt="2025-12-10T14:02:20.050" v="363" actId="114"/>
        <pc:sldMkLst>
          <pc:docMk/>
          <pc:sldMk cId="2229618018" sldId="263"/>
        </pc:sldMkLst>
        <pc:spChg chg="mod">
          <ac:chgData name="VERONICA GHIONNA" userId="df799423-6250-4717-b524-c1ee7c82214c" providerId="ADAL" clId="{2FC1D459-4C4C-4050-BB87-A8E340603A11}" dt="2025-12-10T14:02:20.050" v="363" actId="114"/>
          <ac:spMkLst>
            <pc:docMk/>
            <pc:sldMk cId="2229618018" sldId="263"/>
            <ac:spMk id="6" creationId="{A878D843-DFD5-3FE1-73A9-417A0D4CC64B}"/>
          </ac:spMkLst>
        </pc:spChg>
      </pc:sldChg>
      <pc:sldChg chg="modSp mod">
        <pc:chgData name="VERONICA GHIONNA" userId="df799423-6250-4717-b524-c1ee7c82214c" providerId="ADAL" clId="{2FC1D459-4C4C-4050-BB87-A8E340603A11}" dt="2025-12-10T14:02:23.322" v="364" actId="20577"/>
        <pc:sldMkLst>
          <pc:docMk/>
          <pc:sldMk cId="1501274553" sldId="264"/>
        </pc:sldMkLst>
        <pc:spChg chg="mod">
          <ac:chgData name="VERONICA GHIONNA" userId="df799423-6250-4717-b524-c1ee7c82214c" providerId="ADAL" clId="{2FC1D459-4C4C-4050-BB87-A8E340603A11}" dt="2025-12-10T14:02:23.322" v="364" actId="20577"/>
          <ac:spMkLst>
            <pc:docMk/>
            <pc:sldMk cId="1501274553" sldId="264"/>
            <ac:spMk id="6" creationId="{590787FD-AE7A-CA14-0E74-99B25D8241B4}"/>
          </ac:spMkLst>
        </pc:spChg>
      </pc:sldChg>
      <pc:sldChg chg="modSp mod">
        <pc:chgData name="VERONICA GHIONNA" userId="df799423-6250-4717-b524-c1ee7c82214c" providerId="ADAL" clId="{2FC1D459-4C4C-4050-BB87-A8E340603A11}" dt="2025-12-10T14:01:13.524" v="352" actId="114"/>
        <pc:sldMkLst>
          <pc:docMk/>
          <pc:sldMk cId="938895209" sldId="265"/>
        </pc:sldMkLst>
        <pc:spChg chg="mod">
          <ac:chgData name="VERONICA GHIONNA" userId="df799423-6250-4717-b524-c1ee7c82214c" providerId="ADAL" clId="{2FC1D459-4C4C-4050-BB87-A8E340603A11}" dt="2025-12-10T14:01:13.524" v="352" actId="114"/>
          <ac:spMkLst>
            <pc:docMk/>
            <pc:sldMk cId="938895209" sldId="265"/>
            <ac:spMk id="4" creationId="{A54AB530-3726-2A0B-9B9B-DC4350742947}"/>
          </ac:spMkLst>
        </pc:spChg>
        <pc:spChg chg="mod">
          <ac:chgData name="VERONICA GHIONNA" userId="df799423-6250-4717-b524-c1ee7c82214c" providerId="ADAL" clId="{2FC1D459-4C4C-4050-BB87-A8E340603A11}" dt="2025-12-10T14:00:43.564" v="337" actId="114"/>
          <ac:spMkLst>
            <pc:docMk/>
            <pc:sldMk cId="938895209" sldId="265"/>
            <ac:spMk id="6" creationId="{1F91717B-4005-0F08-F16A-B6D36A664F97}"/>
          </ac:spMkLst>
        </pc:spChg>
        <pc:spChg chg="mod">
          <ac:chgData name="VERONICA GHIONNA" userId="df799423-6250-4717-b524-c1ee7c82214c" providerId="ADAL" clId="{2FC1D459-4C4C-4050-BB87-A8E340603A11}" dt="2025-12-10T14:00:43.564" v="337" actId="114"/>
          <ac:spMkLst>
            <pc:docMk/>
            <pc:sldMk cId="938895209" sldId="265"/>
            <ac:spMk id="7" creationId="{046820EB-CF41-774B-BE99-1F0CBBD672BD}"/>
          </ac:spMkLst>
        </pc:spChg>
        <pc:spChg chg="mod">
          <ac:chgData name="VERONICA GHIONNA" userId="df799423-6250-4717-b524-c1ee7c82214c" providerId="ADAL" clId="{2FC1D459-4C4C-4050-BB87-A8E340603A11}" dt="2025-12-10T14:00:43.564" v="337" actId="114"/>
          <ac:spMkLst>
            <pc:docMk/>
            <pc:sldMk cId="938895209" sldId="265"/>
            <ac:spMk id="8" creationId="{4D451ED7-FA4C-1FF5-0454-54F50A0A85F8}"/>
          </ac:spMkLst>
        </pc:spChg>
      </pc:sldChg>
      <pc:sldChg chg="modSp mod">
        <pc:chgData name="VERONICA GHIONNA" userId="df799423-6250-4717-b524-c1ee7c82214c" providerId="ADAL" clId="{2FC1D459-4C4C-4050-BB87-A8E340603A11}" dt="2025-12-10T14:02:29.203" v="365" actId="20577"/>
        <pc:sldMkLst>
          <pc:docMk/>
          <pc:sldMk cId="1288996147" sldId="266"/>
        </pc:sldMkLst>
        <pc:spChg chg="mod">
          <ac:chgData name="VERONICA GHIONNA" userId="df799423-6250-4717-b524-c1ee7c82214c" providerId="ADAL" clId="{2FC1D459-4C4C-4050-BB87-A8E340603A11}" dt="2025-12-10T14:02:29.203" v="365" actId="20577"/>
          <ac:spMkLst>
            <pc:docMk/>
            <pc:sldMk cId="1288996147" sldId="266"/>
            <ac:spMk id="6" creationId="{3E64CDEE-36D1-C4EE-A713-6921CCBD9855}"/>
          </ac:spMkLst>
        </pc:spChg>
      </pc:sldChg>
      <pc:sldChg chg="modSp mod">
        <pc:chgData name="VERONICA GHIONNA" userId="df799423-6250-4717-b524-c1ee7c82214c" providerId="ADAL" clId="{2FC1D459-4C4C-4050-BB87-A8E340603A11}" dt="2025-12-10T14:06:21.591" v="425" actId="114"/>
        <pc:sldMkLst>
          <pc:docMk/>
          <pc:sldMk cId="537611988" sldId="267"/>
        </pc:sldMkLst>
        <pc:spChg chg="mod">
          <ac:chgData name="VERONICA GHIONNA" userId="df799423-6250-4717-b524-c1ee7c82214c" providerId="ADAL" clId="{2FC1D459-4C4C-4050-BB87-A8E340603A11}" dt="2025-12-10T14:06:21.591" v="425" actId="114"/>
          <ac:spMkLst>
            <pc:docMk/>
            <pc:sldMk cId="537611988" sldId="267"/>
            <ac:spMk id="4" creationId="{0A27858C-D4D9-2AC0-148F-DC153E6F968A}"/>
          </ac:spMkLst>
        </pc:spChg>
      </pc:sldChg>
      <pc:sldChg chg="modSp mod">
        <pc:chgData name="VERONICA GHIONNA" userId="df799423-6250-4717-b524-c1ee7c82214c" providerId="ADAL" clId="{2FC1D459-4C4C-4050-BB87-A8E340603A11}" dt="2025-12-10T14:00:18.064" v="331" actId="1036"/>
        <pc:sldMkLst>
          <pc:docMk/>
          <pc:sldMk cId="3368783863" sldId="268"/>
        </pc:sldMkLst>
        <pc:spChg chg="mod">
          <ac:chgData name="VERONICA GHIONNA" userId="df799423-6250-4717-b524-c1ee7c82214c" providerId="ADAL" clId="{2FC1D459-4C4C-4050-BB87-A8E340603A11}" dt="2025-12-10T14:00:18.064" v="331" actId="1036"/>
          <ac:spMkLst>
            <pc:docMk/>
            <pc:sldMk cId="3368783863" sldId="268"/>
            <ac:spMk id="4" creationId="{D658F82A-5C12-3CB2-E7BB-BF945D7F1C73}"/>
          </ac:spMkLst>
        </pc:spChg>
        <pc:spChg chg="mod">
          <ac:chgData name="VERONICA GHIONNA" userId="df799423-6250-4717-b524-c1ee7c82214c" providerId="ADAL" clId="{2FC1D459-4C4C-4050-BB87-A8E340603A11}" dt="2025-12-10T13:57:55.915" v="167" actId="114"/>
          <ac:spMkLst>
            <pc:docMk/>
            <pc:sldMk cId="3368783863" sldId="268"/>
            <ac:spMk id="7" creationId="{7F70DAA5-B524-AA11-8DF9-1F0AA2CCA3EA}"/>
          </ac:spMkLst>
        </pc:spChg>
        <pc:spChg chg="mod">
          <ac:chgData name="VERONICA GHIONNA" userId="df799423-6250-4717-b524-c1ee7c82214c" providerId="ADAL" clId="{2FC1D459-4C4C-4050-BB87-A8E340603A11}" dt="2025-12-10T14:00:09.279" v="316" actId="1038"/>
          <ac:spMkLst>
            <pc:docMk/>
            <pc:sldMk cId="3368783863" sldId="268"/>
            <ac:spMk id="8" creationId="{461DA178-B086-7CEE-2A26-B1FEE6AF1D08}"/>
          </ac:spMkLst>
        </pc:spChg>
      </pc:sldChg>
      <pc:sldChg chg="addSp delSp modSp new mod ord modNotesTx">
        <pc:chgData name="VERONICA GHIONNA" userId="df799423-6250-4717-b524-c1ee7c82214c" providerId="ADAL" clId="{2FC1D459-4C4C-4050-BB87-A8E340603A11}" dt="2025-12-10T13:53:37.183" v="143" actId="1035"/>
        <pc:sldMkLst>
          <pc:docMk/>
          <pc:sldMk cId="2428146435" sldId="269"/>
        </pc:sldMkLst>
        <pc:spChg chg="del">
          <ac:chgData name="VERONICA GHIONNA" userId="df799423-6250-4717-b524-c1ee7c82214c" providerId="ADAL" clId="{2FC1D459-4C4C-4050-BB87-A8E340603A11}" dt="2025-12-10T13:36:44.325" v="5" actId="478"/>
          <ac:spMkLst>
            <pc:docMk/>
            <pc:sldMk cId="2428146435" sldId="269"/>
            <ac:spMk id="2" creationId="{E97825D7-EFAA-2F87-1A31-799C9E79375A}"/>
          </ac:spMkLst>
        </pc:spChg>
        <pc:spChg chg="mod">
          <ac:chgData name="VERONICA GHIONNA" userId="df799423-6250-4717-b524-c1ee7c82214c" providerId="ADAL" clId="{2FC1D459-4C4C-4050-BB87-A8E340603A11}" dt="2025-12-10T13:53:35.075" v="125" actId="1035"/>
          <ac:spMkLst>
            <pc:docMk/>
            <pc:sldMk cId="2428146435" sldId="269"/>
            <ac:spMk id="3" creationId="{8C2495D3-2AF1-46A5-D833-8AB23351AFE8}"/>
          </ac:spMkLst>
        </pc:spChg>
        <pc:spChg chg="del">
          <ac:chgData name="VERONICA GHIONNA" userId="df799423-6250-4717-b524-c1ee7c82214c" providerId="ADAL" clId="{2FC1D459-4C4C-4050-BB87-A8E340603A11}" dt="2025-12-10T13:36:44.980" v="6" actId="478"/>
          <ac:spMkLst>
            <pc:docMk/>
            <pc:sldMk cId="2428146435" sldId="269"/>
            <ac:spMk id="3" creationId="{D1B52582-731F-2B31-F736-A1E0825DCC0B}"/>
          </ac:spMkLst>
        </pc:spChg>
        <pc:spChg chg="add mod">
          <ac:chgData name="VERONICA GHIONNA" userId="df799423-6250-4717-b524-c1ee7c82214c" providerId="ADAL" clId="{2FC1D459-4C4C-4050-BB87-A8E340603A11}" dt="2025-12-10T13:53:37.183" v="143" actId="1035"/>
          <ac:spMkLst>
            <pc:docMk/>
            <pc:sldMk cId="2428146435" sldId="269"/>
            <ac:spMk id="4" creationId="{3A898EEB-0BA6-5540-2FD6-9D7DDC37EF23}"/>
          </ac:spMkLst>
        </pc:spChg>
        <pc:spChg chg="add del mod">
          <ac:chgData name="VERONICA GHIONNA" userId="df799423-6250-4717-b524-c1ee7c82214c" providerId="ADAL" clId="{2FC1D459-4C4C-4050-BB87-A8E340603A11}" dt="2025-12-10T13:37:31.484" v="17"/>
          <ac:spMkLst>
            <pc:docMk/>
            <pc:sldMk cId="2428146435" sldId="269"/>
            <ac:spMk id="10" creationId="{AE3826E6-DA1F-52BE-6071-8B87211E79CB}"/>
          </ac:spMkLst>
        </pc:spChg>
        <pc:picChg chg="add del">
          <ac:chgData name="VERONICA GHIONNA" userId="df799423-6250-4717-b524-c1ee7c82214c" providerId="ADAL" clId="{2FC1D459-4C4C-4050-BB87-A8E340603A11}" dt="2025-12-10T13:36:49.844" v="8" actId="22"/>
          <ac:picMkLst>
            <pc:docMk/>
            <pc:sldMk cId="2428146435" sldId="269"/>
            <ac:picMk id="5" creationId="{0F429B08-A60B-16B2-FF16-06BD9BA05F4B}"/>
          </ac:picMkLst>
        </pc:picChg>
        <pc:picChg chg="add del">
          <ac:chgData name="VERONICA GHIONNA" userId="df799423-6250-4717-b524-c1ee7c82214c" providerId="ADAL" clId="{2FC1D459-4C4C-4050-BB87-A8E340603A11}" dt="2025-12-10T13:37:10.004" v="10" actId="478"/>
          <ac:picMkLst>
            <pc:docMk/>
            <pc:sldMk cId="2428146435" sldId="269"/>
            <ac:picMk id="7" creationId="{B12021B1-E1AD-112D-1DBF-B6BF81C3F7CD}"/>
          </ac:picMkLst>
        </pc:picChg>
        <pc:picChg chg="add del">
          <ac:chgData name="VERONICA GHIONNA" userId="df799423-6250-4717-b524-c1ee7c82214c" providerId="ADAL" clId="{2FC1D459-4C4C-4050-BB87-A8E340603A11}" dt="2025-12-10T13:37:24.476" v="12" actId="478"/>
          <ac:picMkLst>
            <pc:docMk/>
            <pc:sldMk cId="2428146435" sldId="269"/>
            <ac:picMk id="9" creationId="{F805CEE7-2663-89B6-4443-28293BEE511E}"/>
          </ac:picMkLst>
        </pc:picChg>
        <pc:picChg chg="add del">
          <ac:chgData name="VERONICA GHIONNA" userId="df799423-6250-4717-b524-c1ee7c82214c" providerId="ADAL" clId="{2FC1D459-4C4C-4050-BB87-A8E340603A11}" dt="2025-12-10T13:37:31.483" v="15" actId="478"/>
          <ac:picMkLst>
            <pc:docMk/>
            <pc:sldMk cId="2428146435" sldId="269"/>
            <ac:picMk id="12" creationId="{1D956AA2-AC32-D0F1-0991-5141B5018C77}"/>
          </ac:picMkLst>
        </pc:picChg>
        <pc:picChg chg="add del">
          <ac:chgData name="VERONICA GHIONNA" userId="df799423-6250-4717-b524-c1ee7c82214c" providerId="ADAL" clId="{2FC1D459-4C4C-4050-BB87-A8E340603A11}" dt="2025-12-10T13:38:43.797" v="19" actId="478"/>
          <ac:picMkLst>
            <pc:docMk/>
            <pc:sldMk cId="2428146435" sldId="269"/>
            <ac:picMk id="14" creationId="{FC141AA9-54A2-C5AB-4AD1-3B871843EA3A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301543" cy="34145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5623372" y="0"/>
            <a:ext cx="4301543" cy="34145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7F8611B-2EA7-4B3E-AC24-E986A67BEF87}" type="datetimeFigureOut">
              <a:rPr lang="it-IT" smtClean="0"/>
              <a:t>11/12/2025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3306763" y="849313"/>
            <a:ext cx="3313112" cy="229393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992664" y="3271382"/>
            <a:ext cx="7941310" cy="267658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6456219"/>
            <a:ext cx="4301543" cy="34145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5623372" y="6456219"/>
            <a:ext cx="4301543" cy="34145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9B1497B-F482-4D4B-A8D1-FC2BE6F1868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765490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9B1497B-F482-4D4B-A8D1-FC2BE6F1868C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12329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9B1497B-F482-4D4B-A8D1-FC2BE6F1868C}" type="slidenum">
              <a:rPr lang="it-IT" smtClean="0"/>
              <a:t>2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4443473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9B1497B-F482-4D4B-A8D1-FC2BE6F1868C}" type="slidenum">
              <a:rPr lang="it-IT" smtClean="0"/>
              <a:t>3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814946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96" indent="0" algn="ctr">
              <a:buNone/>
              <a:defRPr sz="2000"/>
            </a:lvl2pPr>
            <a:lvl3pPr marL="914392" indent="0" algn="ctr">
              <a:buNone/>
              <a:defRPr sz="1800"/>
            </a:lvl3pPr>
            <a:lvl4pPr marL="1371588" indent="0" algn="ctr">
              <a:buNone/>
              <a:defRPr sz="1600"/>
            </a:lvl4pPr>
            <a:lvl5pPr marL="1828784" indent="0" algn="ctr">
              <a:buNone/>
              <a:defRPr sz="1600"/>
            </a:lvl5pPr>
            <a:lvl6pPr marL="2285980" indent="0" algn="ctr">
              <a:buNone/>
              <a:defRPr sz="1600"/>
            </a:lvl6pPr>
            <a:lvl7pPr marL="2743176" indent="0" algn="ctr">
              <a:buNone/>
              <a:defRPr sz="1600"/>
            </a:lvl7pPr>
            <a:lvl8pPr marL="3200372" indent="0" algn="ctr">
              <a:buNone/>
              <a:defRPr sz="1600"/>
            </a:lvl8pPr>
            <a:lvl9pPr marL="3657568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C1A43-994A-47F5-BF5A-860E4C600708}" type="datetimeFigureOut">
              <a:rPr lang="it-IT" smtClean="0"/>
              <a:t>11/12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318FA-B1D9-4743-8823-51F038BF96E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720981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C1A43-994A-47F5-BF5A-860E4C600708}" type="datetimeFigureOut">
              <a:rPr lang="it-IT" smtClean="0"/>
              <a:t>11/12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318FA-B1D9-4743-8823-51F038BF96E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728801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3" y="365125"/>
            <a:ext cx="2135982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40" y="365125"/>
            <a:ext cx="6284118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C1A43-994A-47F5-BF5A-860E4C600708}" type="datetimeFigureOut">
              <a:rPr lang="it-IT" smtClean="0"/>
              <a:t>11/12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318FA-B1D9-4743-8823-51F038BF96E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721666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C1A43-994A-47F5-BF5A-860E4C600708}" type="datetimeFigureOut">
              <a:rPr lang="it-IT" smtClean="0"/>
              <a:t>11/12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318FA-B1D9-4743-8823-51F038BF96E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891353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80" y="1709741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80" y="4589466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196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392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588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784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598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176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372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568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C1A43-994A-47F5-BF5A-860E4C600708}" type="datetimeFigureOut">
              <a:rPr lang="it-IT" smtClean="0"/>
              <a:t>11/12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318FA-B1D9-4743-8823-51F038BF96E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903945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C1A43-994A-47F5-BF5A-860E4C600708}" type="datetimeFigureOut">
              <a:rPr lang="it-IT" smtClean="0"/>
              <a:t>11/12/202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318FA-B1D9-4743-8823-51F038BF96E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904727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9" y="365127"/>
            <a:ext cx="8543925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96" indent="0">
              <a:buNone/>
              <a:defRPr sz="2000" b="1"/>
            </a:lvl2pPr>
            <a:lvl3pPr marL="914392" indent="0">
              <a:buNone/>
              <a:defRPr sz="1800" b="1"/>
            </a:lvl3pPr>
            <a:lvl4pPr marL="1371588" indent="0">
              <a:buNone/>
              <a:defRPr sz="1600" b="1"/>
            </a:lvl4pPr>
            <a:lvl5pPr marL="1828784" indent="0">
              <a:buNone/>
              <a:defRPr sz="1600" b="1"/>
            </a:lvl5pPr>
            <a:lvl6pPr marL="2285980" indent="0">
              <a:buNone/>
              <a:defRPr sz="1600" b="1"/>
            </a:lvl6pPr>
            <a:lvl7pPr marL="2743176" indent="0">
              <a:buNone/>
              <a:defRPr sz="1600" b="1"/>
            </a:lvl7pPr>
            <a:lvl8pPr marL="3200372" indent="0">
              <a:buNone/>
              <a:defRPr sz="1600" b="1"/>
            </a:lvl8pPr>
            <a:lvl9pPr marL="3657568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96" indent="0">
              <a:buNone/>
              <a:defRPr sz="2000" b="1"/>
            </a:lvl2pPr>
            <a:lvl3pPr marL="914392" indent="0">
              <a:buNone/>
              <a:defRPr sz="1800" b="1"/>
            </a:lvl3pPr>
            <a:lvl4pPr marL="1371588" indent="0">
              <a:buNone/>
              <a:defRPr sz="1600" b="1"/>
            </a:lvl4pPr>
            <a:lvl5pPr marL="1828784" indent="0">
              <a:buNone/>
              <a:defRPr sz="1600" b="1"/>
            </a:lvl5pPr>
            <a:lvl6pPr marL="2285980" indent="0">
              <a:buNone/>
              <a:defRPr sz="1600" b="1"/>
            </a:lvl6pPr>
            <a:lvl7pPr marL="2743176" indent="0">
              <a:buNone/>
              <a:defRPr sz="1600" b="1"/>
            </a:lvl7pPr>
            <a:lvl8pPr marL="3200372" indent="0">
              <a:buNone/>
              <a:defRPr sz="1600" b="1"/>
            </a:lvl8pPr>
            <a:lvl9pPr marL="3657568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C1A43-994A-47F5-BF5A-860E4C600708}" type="datetimeFigureOut">
              <a:rPr lang="it-IT" smtClean="0"/>
              <a:t>11/12/2025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318FA-B1D9-4743-8823-51F038BF96E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972675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C1A43-994A-47F5-BF5A-860E4C600708}" type="datetimeFigureOut">
              <a:rPr lang="it-IT" smtClean="0"/>
              <a:t>11/12/2025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318FA-B1D9-4743-8823-51F038BF96E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051789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C1A43-994A-47F5-BF5A-860E4C600708}" type="datetimeFigureOut">
              <a:rPr lang="it-IT" smtClean="0"/>
              <a:t>11/12/2025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318FA-B1D9-4743-8823-51F038BF96E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92883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9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1" y="987428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9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96" indent="0">
              <a:buNone/>
              <a:defRPr sz="1400"/>
            </a:lvl2pPr>
            <a:lvl3pPr marL="914392" indent="0">
              <a:buNone/>
              <a:defRPr sz="1200"/>
            </a:lvl3pPr>
            <a:lvl4pPr marL="1371588" indent="0">
              <a:buNone/>
              <a:defRPr sz="1000"/>
            </a:lvl4pPr>
            <a:lvl5pPr marL="1828784" indent="0">
              <a:buNone/>
              <a:defRPr sz="1000"/>
            </a:lvl5pPr>
            <a:lvl6pPr marL="2285980" indent="0">
              <a:buNone/>
              <a:defRPr sz="1000"/>
            </a:lvl6pPr>
            <a:lvl7pPr marL="2743176" indent="0">
              <a:buNone/>
              <a:defRPr sz="1000"/>
            </a:lvl7pPr>
            <a:lvl8pPr marL="3200372" indent="0">
              <a:buNone/>
              <a:defRPr sz="1000"/>
            </a:lvl8pPr>
            <a:lvl9pPr marL="3657568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C1A43-994A-47F5-BF5A-860E4C600708}" type="datetimeFigureOut">
              <a:rPr lang="it-IT" smtClean="0"/>
              <a:t>11/12/202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318FA-B1D9-4743-8823-51F038BF96E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389439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9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1" y="987428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196" indent="0">
              <a:buNone/>
              <a:defRPr sz="2800"/>
            </a:lvl2pPr>
            <a:lvl3pPr marL="914392" indent="0">
              <a:buNone/>
              <a:defRPr sz="2400"/>
            </a:lvl3pPr>
            <a:lvl4pPr marL="1371588" indent="0">
              <a:buNone/>
              <a:defRPr sz="2000"/>
            </a:lvl4pPr>
            <a:lvl5pPr marL="1828784" indent="0">
              <a:buNone/>
              <a:defRPr sz="2000"/>
            </a:lvl5pPr>
            <a:lvl6pPr marL="2285980" indent="0">
              <a:buNone/>
              <a:defRPr sz="2000"/>
            </a:lvl6pPr>
            <a:lvl7pPr marL="2743176" indent="0">
              <a:buNone/>
              <a:defRPr sz="2000"/>
            </a:lvl7pPr>
            <a:lvl8pPr marL="3200372" indent="0">
              <a:buNone/>
              <a:defRPr sz="2000"/>
            </a:lvl8pPr>
            <a:lvl9pPr marL="3657568" indent="0">
              <a:buNone/>
              <a:defRPr sz="2000"/>
            </a:lvl9pPr>
          </a:lstStyle>
          <a:p>
            <a:r>
              <a:rPr lang="it-IT"/>
              <a:t>Fare clic sull'icona per inserire un'immagin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9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96" indent="0">
              <a:buNone/>
              <a:defRPr sz="1400"/>
            </a:lvl2pPr>
            <a:lvl3pPr marL="914392" indent="0">
              <a:buNone/>
              <a:defRPr sz="1200"/>
            </a:lvl3pPr>
            <a:lvl4pPr marL="1371588" indent="0">
              <a:buNone/>
              <a:defRPr sz="1000"/>
            </a:lvl4pPr>
            <a:lvl5pPr marL="1828784" indent="0">
              <a:buNone/>
              <a:defRPr sz="1000"/>
            </a:lvl5pPr>
            <a:lvl6pPr marL="2285980" indent="0">
              <a:buNone/>
              <a:defRPr sz="1000"/>
            </a:lvl6pPr>
            <a:lvl7pPr marL="2743176" indent="0">
              <a:buNone/>
              <a:defRPr sz="1000"/>
            </a:lvl7pPr>
            <a:lvl8pPr marL="3200372" indent="0">
              <a:buNone/>
              <a:defRPr sz="1000"/>
            </a:lvl8pPr>
            <a:lvl9pPr marL="3657568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C1A43-994A-47F5-BF5A-860E4C600708}" type="datetimeFigureOut">
              <a:rPr lang="it-IT" smtClean="0"/>
              <a:t>11/12/202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318FA-B1D9-4743-8823-51F038BF96E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726614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9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9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3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C3C1A43-994A-47F5-BF5A-860E4C600708}" type="datetimeFigureOut">
              <a:rPr lang="it-IT" smtClean="0"/>
              <a:t>11/12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4" y="6356353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3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2A318FA-B1D9-4743-8823-51F038BF96E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05605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392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8" indent="-228598" algn="l" defTabSz="914392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94" indent="-228598" algn="l" defTabSz="91439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90" indent="-228598" algn="l" defTabSz="91439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86" indent="-228598" algn="l" defTabSz="91439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82" indent="-228598" algn="l" defTabSz="91439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78" indent="-228598" algn="l" defTabSz="91439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74" indent="-228598" algn="l" defTabSz="91439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70" indent="-228598" algn="l" defTabSz="91439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66" indent="-228598" algn="l" defTabSz="91439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9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96" algn="l" defTabSz="91439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92" algn="l" defTabSz="91439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88" algn="l" defTabSz="91439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84" algn="l" defTabSz="91439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80" algn="l" defTabSz="91439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76" algn="l" defTabSz="91439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72" algn="l" defTabSz="91439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68" algn="l" defTabSz="91439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sellaDiTesto 2">
            <a:extLst>
              <a:ext uri="{FF2B5EF4-FFF2-40B4-BE49-F238E27FC236}">
                <a16:creationId xmlns:a16="http://schemas.microsoft.com/office/drawing/2014/main" id="{8C2495D3-2AF1-46A5-D833-8AB23351AFE8}"/>
              </a:ext>
            </a:extLst>
          </p:cNvPr>
          <p:cNvSpPr txBox="1"/>
          <p:nvPr/>
        </p:nvSpPr>
        <p:spPr>
          <a:xfrm>
            <a:off x="123217" y="4040045"/>
            <a:ext cx="9487711" cy="80021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it-IT" sz="1400" b="1" i="0" u="none" strike="noStrike" baseline="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Supplementary</a:t>
            </a:r>
            <a:r>
              <a:rPr lang="it-IT" sz="1400" b="1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 Figure 1 </a:t>
            </a:r>
            <a:r>
              <a:rPr lang="it-IT" sz="1400" i="0" u="none" strike="noStrike" baseline="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Tanglegrams</a:t>
            </a:r>
            <a:r>
              <a:rPr lang="it-IT" sz="140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 </a:t>
            </a:r>
            <a:r>
              <a:rPr lang="it-IT" sz="1400" i="0" u="none" strike="noStrike" baseline="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comparing</a:t>
            </a:r>
            <a:r>
              <a:rPr lang="it-IT" sz="140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 MLST and </a:t>
            </a:r>
            <a:r>
              <a:rPr lang="it-IT" sz="1400" i="0" u="none" strike="noStrike" baseline="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phylogenomic</a:t>
            </a:r>
            <a:r>
              <a:rPr lang="it-IT" sz="140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 </a:t>
            </a:r>
            <a:r>
              <a:rPr lang="it-IT" sz="1400" i="0" u="none" strike="noStrike" baseline="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species</a:t>
            </a:r>
            <a:r>
              <a:rPr lang="it-IT" sz="140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 </a:t>
            </a:r>
            <a:r>
              <a:rPr lang="it-IT" sz="1400" i="0" u="none" strike="noStrike" baseline="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trees</a:t>
            </a:r>
            <a:r>
              <a:rPr lang="it-IT" sz="140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 </a:t>
            </a:r>
            <a:r>
              <a:rPr lang="it-IT" sz="1400" i="0" u="none" strike="noStrike" baseline="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across</a:t>
            </a:r>
            <a:r>
              <a:rPr lang="it-IT" sz="140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 </a:t>
            </a:r>
            <a:r>
              <a:rPr lang="it-IT" sz="1400" i="0" u="none" strike="noStrike" baseline="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Nectriaceae</a:t>
            </a:r>
            <a:r>
              <a:rPr lang="it-IT" sz="140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. </a:t>
            </a:r>
            <a:r>
              <a:rPr lang="it-IT" sz="1400" i="0" u="none" strike="noStrike" baseline="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Each</a:t>
            </a:r>
            <a:r>
              <a:rPr lang="it-IT" sz="140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 panel shows a </a:t>
            </a:r>
            <a:r>
              <a:rPr lang="it-IT" sz="1400" i="0" u="none" strike="noStrike" baseline="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tanglegram</a:t>
            </a:r>
            <a:r>
              <a:rPr lang="it-IT" sz="140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 </a:t>
            </a:r>
            <a:r>
              <a:rPr lang="it-IT" sz="1400" i="0" u="none" strike="noStrike" baseline="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contrasting</a:t>
            </a:r>
            <a:r>
              <a:rPr lang="it-IT" sz="140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 the MLST </a:t>
            </a:r>
            <a:r>
              <a:rPr lang="it-IT" sz="1400" i="0" u="none" strike="noStrike" baseline="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phylogeny</a:t>
            </a:r>
            <a:r>
              <a:rPr lang="it-IT" sz="140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 (19 locus </a:t>
            </a:r>
            <a:r>
              <a:rPr lang="it-IT" sz="1400" i="0" u="none" strike="noStrike" baseline="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concatenated</a:t>
            </a:r>
            <a:r>
              <a:rPr lang="it-IT" sz="140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 </a:t>
            </a:r>
            <a:r>
              <a:rPr lang="it-IT" sz="1400" i="0" u="none" strike="noStrike" baseline="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alignment</a:t>
            </a:r>
            <a:r>
              <a:rPr lang="it-IT" sz="140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) with the </a:t>
            </a:r>
            <a:r>
              <a:rPr lang="it-IT" sz="1400" i="0" u="none" strike="noStrike" baseline="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phylogenomic</a:t>
            </a:r>
            <a:r>
              <a:rPr lang="it-IT" sz="140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 </a:t>
            </a:r>
            <a:r>
              <a:rPr lang="it-IT" sz="1400" i="0" u="none" strike="noStrike" baseline="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tree</a:t>
            </a:r>
            <a:r>
              <a:rPr lang="it-IT" sz="140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 </a:t>
            </a:r>
            <a:r>
              <a:rPr lang="it-IT" sz="1400" i="0" u="none" strike="noStrike" baseline="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in</a:t>
            </a:r>
            <a:r>
              <a:rPr lang="it-IT" sz="140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f</a:t>
            </a:r>
            <a:r>
              <a:rPr lang="it-IT" sz="1400" i="0" u="none" strike="noStrike" baseline="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erred</a:t>
            </a:r>
            <a:r>
              <a:rPr lang="it-IT" sz="140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 from 763 single-copy </a:t>
            </a:r>
            <a:r>
              <a:rPr lang="it-IT" sz="1400" i="0" u="none" strike="noStrike" baseline="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orthologs</a:t>
            </a:r>
            <a:r>
              <a:rPr lang="it-IT" sz="140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. </a:t>
            </a:r>
            <a:r>
              <a:rPr lang="it-IT" sz="1400" i="0" u="none" strike="noStrike" baseline="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Both</a:t>
            </a:r>
            <a:r>
              <a:rPr lang="it-IT" sz="140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 </a:t>
            </a:r>
            <a:r>
              <a:rPr lang="it-IT" sz="1400" i="0" u="none" strike="noStrike" baseline="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trees</a:t>
            </a:r>
            <a:r>
              <a:rPr lang="it-IT" sz="140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 are </a:t>
            </a:r>
            <a:r>
              <a:rPr lang="it-IT" sz="1400" i="0" u="none" strike="noStrike" baseline="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midpoint</a:t>
            </a:r>
            <a:r>
              <a:rPr lang="it-IT" sz="140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 </a:t>
            </a:r>
            <a:r>
              <a:rPr lang="it-IT" sz="1400" i="0" u="none" strike="noStrike" baseline="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rooted</a:t>
            </a:r>
            <a:r>
              <a:rPr lang="it-IT" sz="180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.</a:t>
            </a:r>
          </a:p>
        </p:txBody>
      </p: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3A898EEB-0BA6-5540-2FD6-9D7DDC37EF23}"/>
              </a:ext>
            </a:extLst>
          </p:cNvPr>
          <p:cNvSpPr txBox="1"/>
          <p:nvPr/>
        </p:nvSpPr>
        <p:spPr>
          <a:xfrm>
            <a:off x="123217" y="310387"/>
            <a:ext cx="9721173" cy="145321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800"/>
              </a:spcAft>
              <a:buNone/>
              <a:tabLst>
                <a:tab pos="5220970" algn="l"/>
              </a:tabLst>
            </a:pPr>
            <a:r>
              <a:rPr lang="en-US" sz="20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In genomes we trust: assessing genomic reliability within the family </a:t>
            </a:r>
            <a:r>
              <a:rPr lang="en-US" sz="2000" b="1" kern="1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Nectriaceae</a:t>
            </a:r>
            <a:endParaRPr lang="it-IT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  <a:spcAft>
                <a:spcPts val="800"/>
              </a:spcAft>
              <a:buNone/>
            </a:pPr>
            <a:r>
              <a:rPr lang="it-IT" sz="14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Villani A.</a:t>
            </a:r>
            <a:r>
              <a:rPr lang="it-IT" sz="1400" b="1" kern="1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1</a:t>
            </a:r>
            <a:r>
              <a:rPr lang="it-IT" sz="14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, Ghionna V.</a:t>
            </a:r>
            <a:r>
              <a:rPr lang="it-IT" sz="1400" b="1" kern="1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1</a:t>
            </a:r>
            <a:r>
              <a:rPr lang="it-IT" sz="14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, Susca A.</a:t>
            </a:r>
            <a:r>
              <a:rPr lang="it-IT" sz="1400" b="1" kern="1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1</a:t>
            </a:r>
            <a:r>
              <a:rPr lang="it-IT" sz="14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, (</a:t>
            </a:r>
            <a:r>
              <a:rPr lang="it-IT" sz="1400" b="1" kern="1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Geiser</a:t>
            </a:r>
            <a:r>
              <a:rPr lang="it-IT" sz="14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M.D.), Menicucci A</a:t>
            </a:r>
            <a:r>
              <a:rPr lang="it-IT" sz="1400" b="1" kern="1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2</a:t>
            </a:r>
            <a:r>
              <a:rPr lang="it-IT" sz="14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., Prodi A.</a:t>
            </a:r>
            <a:r>
              <a:rPr lang="it-IT" sz="1400" b="1" kern="1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2</a:t>
            </a:r>
            <a:r>
              <a:rPr lang="it-IT" sz="14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, </a:t>
            </a:r>
            <a:r>
              <a:rPr lang="it-IT" sz="1400" b="1" kern="1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aino</a:t>
            </a:r>
            <a:r>
              <a:rPr lang="it-IT" sz="14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L.</a:t>
            </a:r>
            <a:r>
              <a:rPr lang="it-IT" sz="1400" b="1" kern="1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3</a:t>
            </a:r>
            <a:r>
              <a:rPr lang="it-IT" sz="14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, Moretti A.</a:t>
            </a:r>
            <a:r>
              <a:rPr lang="it-IT" sz="1400" b="1" kern="1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1</a:t>
            </a:r>
            <a:r>
              <a:rPr lang="it-IT" sz="14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*, Baroncelli R</a:t>
            </a:r>
            <a:r>
              <a:rPr lang="it-IT" sz="1400" b="1" kern="1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2</a:t>
            </a:r>
            <a:endParaRPr lang="it-IT" sz="14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algn="just" fontAlgn="base">
              <a:buNone/>
            </a:pPr>
            <a:r>
              <a:rPr lang="en-US" sz="1100" i="1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1</a:t>
            </a:r>
            <a:r>
              <a:rPr lang="en-US" sz="11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Institute of Sciences of Food Production, National Research Council (CNR-ISPA), Bari, Italy</a:t>
            </a:r>
            <a:r>
              <a:rPr lang="en-US" sz="1100" b="1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 </a:t>
            </a:r>
            <a:endParaRPr lang="it-IT" sz="16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 fontAlgn="base">
              <a:buNone/>
            </a:pPr>
            <a:r>
              <a:rPr lang="en-US" sz="11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2 </a:t>
            </a:r>
            <a:r>
              <a:rPr lang="en-US" sz="11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Department of Agricultural and Food Sciences (DISTAL), University of Bologna, Bologna, Italy</a:t>
            </a:r>
            <a:r>
              <a:rPr lang="en-US" sz="1100" b="1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 </a:t>
            </a:r>
            <a:endParaRPr lang="it-IT" sz="16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 fontAlgn="base">
              <a:buNone/>
            </a:pPr>
            <a:r>
              <a:rPr lang="en-US" sz="1100" i="1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3</a:t>
            </a:r>
            <a:r>
              <a:rPr lang="en-US" sz="11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Department of Environmental Biology, 00185, Sapienza University of Rome, Rome, Italy </a:t>
            </a:r>
            <a:endParaRPr lang="it-IT" sz="16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2814643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8F571DC-AB2D-6D1E-0540-1DCE23EFAC3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magine 4">
            <a:extLst>
              <a:ext uri="{FF2B5EF4-FFF2-40B4-BE49-F238E27FC236}">
                <a16:creationId xmlns:a16="http://schemas.microsoft.com/office/drawing/2014/main" id="{9C1F47FC-8333-FEDF-FCA9-E9D09BBE4788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9518" t="6561" r="10192" b="8977"/>
          <a:stretch>
            <a:fillRect/>
          </a:stretch>
        </p:blipFill>
        <p:spPr>
          <a:xfrm>
            <a:off x="57688" y="398347"/>
            <a:ext cx="9790624" cy="6092987"/>
          </a:xfrm>
          <a:prstGeom prst="rect">
            <a:avLst/>
          </a:prstGeom>
        </p:spPr>
      </p:pic>
      <p:sp>
        <p:nvSpPr>
          <p:cNvPr id="2" name="CasellaDiTesto 1">
            <a:extLst>
              <a:ext uri="{FF2B5EF4-FFF2-40B4-BE49-F238E27FC236}">
                <a16:creationId xmlns:a16="http://schemas.microsoft.com/office/drawing/2014/main" id="{616FD4A6-DA2A-2567-AD86-5CAA5ABFDE83}"/>
              </a:ext>
            </a:extLst>
          </p:cNvPr>
          <p:cNvSpPr txBox="1"/>
          <p:nvPr/>
        </p:nvSpPr>
        <p:spPr>
          <a:xfrm>
            <a:off x="1410366" y="6516225"/>
            <a:ext cx="900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20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LST</a:t>
            </a:r>
          </a:p>
        </p:txBody>
      </p:sp>
      <p:sp>
        <p:nvSpPr>
          <p:cNvPr id="3" name="CasellaDiTesto 2">
            <a:extLst>
              <a:ext uri="{FF2B5EF4-FFF2-40B4-BE49-F238E27FC236}">
                <a16:creationId xmlns:a16="http://schemas.microsoft.com/office/drawing/2014/main" id="{D37F6CA3-7C8F-E6F6-2489-D4CA7F5F7BB3}"/>
              </a:ext>
            </a:extLst>
          </p:cNvPr>
          <p:cNvSpPr txBox="1"/>
          <p:nvPr/>
        </p:nvSpPr>
        <p:spPr>
          <a:xfrm>
            <a:off x="7854235" y="6516225"/>
            <a:ext cx="900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20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WGS-</a:t>
            </a:r>
            <a:r>
              <a:rPr lang="it-IT" sz="120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ased</a:t>
            </a:r>
            <a:endParaRPr lang="it-IT" sz="120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2693F5BC-D98E-433F-BD98-2BF5726EB774}"/>
              </a:ext>
            </a:extLst>
          </p:cNvPr>
          <p:cNvSpPr txBox="1"/>
          <p:nvPr/>
        </p:nvSpPr>
        <p:spPr>
          <a:xfrm>
            <a:off x="0" y="83485"/>
            <a:ext cx="990600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1400" b="1" kern="0" dirty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The </a:t>
            </a:r>
            <a:r>
              <a:rPr lang="it-IT" sz="1400" b="1" i="1" kern="0" dirty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Fusarium </a:t>
            </a:r>
            <a:r>
              <a:rPr lang="it-IT" sz="1400" b="1" i="1" kern="0" dirty="0" err="1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sambucinum</a:t>
            </a:r>
            <a:r>
              <a:rPr lang="it-IT" sz="1400" b="1" kern="0" dirty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it-IT" sz="1400" b="1" kern="0" dirty="0" err="1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species</a:t>
            </a:r>
            <a:r>
              <a:rPr lang="it-IT" sz="1400" b="1" kern="0" dirty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it-IT" sz="1400" b="1" kern="0" dirty="0" err="1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complex</a:t>
            </a:r>
            <a:endParaRPr lang="it-IT" sz="1400" b="1" i="1" kern="0" dirty="0">
              <a:solidFill>
                <a:schemeClr val="accent2">
                  <a:lumMod val="75000"/>
                </a:schemeClr>
              </a:solidFill>
              <a:latin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6389380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CF96001-DF16-1259-DAFC-EE82FC17CEE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>
            <a:extLst>
              <a:ext uri="{FF2B5EF4-FFF2-40B4-BE49-F238E27FC236}">
                <a16:creationId xmlns:a16="http://schemas.microsoft.com/office/drawing/2014/main" id="{D430C3F4-72CA-21BA-E47E-176DD8425C90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7410" t="6172" r="7602" b="4444"/>
          <a:stretch>
            <a:fillRect/>
          </a:stretch>
        </p:blipFill>
        <p:spPr>
          <a:xfrm>
            <a:off x="228600" y="865128"/>
            <a:ext cx="9448800" cy="5127744"/>
          </a:xfrm>
          <a:prstGeom prst="rect">
            <a:avLst/>
          </a:prstGeom>
        </p:spPr>
      </p:pic>
      <p:sp>
        <p:nvSpPr>
          <p:cNvPr id="2" name="CasellaDiTesto 1">
            <a:extLst>
              <a:ext uri="{FF2B5EF4-FFF2-40B4-BE49-F238E27FC236}">
                <a16:creationId xmlns:a16="http://schemas.microsoft.com/office/drawing/2014/main" id="{3BAA0D61-5C62-234C-0A09-4E325F773C13}"/>
              </a:ext>
            </a:extLst>
          </p:cNvPr>
          <p:cNvSpPr txBox="1"/>
          <p:nvPr/>
        </p:nvSpPr>
        <p:spPr>
          <a:xfrm>
            <a:off x="1410366" y="6429987"/>
            <a:ext cx="900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20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LST</a:t>
            </a:r>
          </a:p>
        </p:txBody>
      </p: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E4B87CD3-2965-C06C-A037-98846E7F16B5}"/>
              </a:ext>
            </a:extLst>
          </p:cNvPr>
          <p:cNvSpPr txBox="1"/>
          <p:nvPr/>
        </p:nvSpPr>
        <p:spPr>
          <a:xfrm>
            <a:off x="7854235" y="6429987"/>
            <a:ext cx="900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20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WGS-</a:t>
            </a:r>
            <a:r>
              <a:rPr lang="it-IT" sz="120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ased</a:t>
            </a:r>
            <a:endParaRPr lang="it-IT" sz="120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" name="CasellaDiTesto 4">
            <a:extLst>
              <a:ext uri="{FF2B5EF4-FFF2-40B4-BE49-F238E27FC236}">
                <a16:creationId xmlns:a16="http://schemas.microsoft.com/office/drawing/2014/main" id="{2A4D1599-7293-346A-4B4C-BEF34AAD6B8D}"/>
              </a:ext>
            </a:extLst>
          </p:cNvPr>
          <p:cNvSpPr txBox="1"/>
          <p:nvPr/>
        </p:nvSpPr>
        <p:spPr>
          <a:xfrm>
            <a:off x="0" y="170302"/>
            <a:ext cx="990600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1400" b="1" kern="0" dirty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The </a:t>
            </a:r>
            <a:r>
              <a:rPr lang="it-IT" sz="1400" b="1" i="1" kern="0" dirty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Fusarium </a:t>
            </a:r>
            <a:r>
              <a:rPr lang="it-IT" sz="1400" b="1" i="1" kern="0" dirty="0" err="1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concolor</a:t>
            </a:r>
            <a:r>
              <a:rPr lang="it-IT" sz="1400" b="1" i="1" kern="0" dirty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it-IT" sz="1400" b="1" i="1" kern="0" dirty="0" err="1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babinda</a:t>
            </a:r>
            <a:r>
              <a:rPr lang="it-IT" sz="1400" b="1" i="1" kern="0" dirty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it-IT" sz="1400" b="1" i="1" kern="0" dirty="0" err="1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burgessii</a:t>
            </a:r>
            <a:r>
              <a:rPr lang="it-IT" sz="1400" b="1" i="1" kern="0" dirty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it-IT" sz="1400" b="1" i="1" kern="0" dirty="0" err="1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redolens</a:t>
            </a:r>
            <a:r>
              <a:rPr lang="it-IT" sz="1400" b="1" i="1" kern="0" dirty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it-IT" sz="1400" b="1" kern="0" dirty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and </a:t>
            </a:r>
            <a:r>
              <a:rPr lang="it-IT" sz="1400" b="1" i="1" kern="0" dirty="0" err="1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newnesense</a:t>
            </a:r>
            <a:r>
              <a:rPr lang="it-IT" sz="1400" b="1" i="1" kern="0" dirty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it-IT" sz="1400" b="1" kern="0" dirty="0" err="1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species</a:t>
            </a:r>
            <a:r>
              <a:rPr lang="it-IT" sz="1400" b="1" kern="0" dirty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it-IT" sz="1400" b="1" kern="0" dirty="0" err="1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complexes</a:t>
            </a:r>
            <a:endParaRPr lang="it-IT" sz="1400" b="1" kern="0" dirty="0">
              <a:solidFill>
                <a:schemeClr val="accent2">
                  <a:lumMod val="75000"/>
                </a:schemeClr>
              </a:solidFill>
              <a:latin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6642CDF7-EFDB-1559-1136-36DA03026C3C}"/>
              </a:ext>
            </a:extLst>
          </p:cNvPr>
          <p:cNvSpPr txBox="1"/>
          <p:nvPr/>
        </p:nvSpPr>
        <p:spPr>
          <a:xfrm>
            <a:off x="619363" y="5181541"/>
            <a:ext cx="81032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800" b="1" i="1" kern="0">
                <a:latin typeface="Calibri" panose="020F0502020204030204" pitchFamily="34" charset="0"/>
                <a:cs typeface="Arial" panose="020B0604020202020204" pitchFamily="34" charset="0"/>
              </a:defRPr>
            </a:lvl1pPr>
          </a:lstStyle>
          <a:p>
            <a:r>
              <a:rPr lang="it-IT" sz="1200" i="0" err="1"/>
              <a:t>Concolor</a:t>
            </a:r>
            <a:r>
              <a:rPr lang="it-IT" sz="1200" i="0"/>
              <a:t> </a:t>
            </a: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62C77BEA-40FD-3342-A421-2EC7470D7222}"/>
              </a:ext>
            </a:extLst>
          </p:cNvPr>
          <p:cNvSpPr txBox="1"/>
          <p:nvPr/>
        </p:nvSpPr>
        <p:spPr>
          <a:xfrm>
            <a:off x="1436122" y="915194"/>
            <a:ext cx="81032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800" b="1" i="1" kern="0">
                <a:latin typeface="Calibri" panose="020F0502020204030204" pitchFamily="34" charset="0"/>
                <a:cs typeface="Arial" panose="020B0604020202020204" pitchFamily="34" charset="0"/>
              </a:defRPr>
            </a:lvl1pPr>
          </a:lstStyle>
          <a:p>
            <a:r>
              <a:rPr lang="it-IT" sz="1200" i="0" dirty="0" err="1"/>
              <a:t>Burgessii</a:t>
            </a:r>
            <a:r>
              <a:rPr lang="it-IT" sz="1200" i="0" dirty="0"/>
              <a:t> </a:t>
            </a:r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34D09DC0-CCC3-FD43-A020-2B5BE60309D0}"/>
              </a:ext>
            </a:extLst>
          </p:cNvPr>
          <p:cNvSpPr txBox="1"/>
          <p:nvPr/>
        </p:nvSpPr>
        <p:spPr>
          <a:xfrm>
            <a:off x="2316805" y="4067520"/>
            <a:ext cx="109299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800" b="1" i="1" kern="0">
                <a:latin typeface="Calibri" panose="020F0502020204030204" pitchFamily="34" charset="0"/>
                <a:cs typeface="Arial" panose="020B0604020202020204" pitchFamily="34" charset="0"/>
              </a:defRPr>
            </a:lvl1pPr>
          </a:lstStyle>
          <a:p>
            <a:r>
              <a:rPr lang="it-IT" sz="1200" i="0" err="1"/>
              <a:t>Newnesense</a:t>
            </a:r>
            <a:endParaRPr lang="it-IT" sz="1200" i="0"/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09BD9CF5-103E-02A3-94DA-9AAB2B82ABFC}"/>
              </a:ext>
            </a:extLst>
          </p:cNvPr>
          <p:cNvSpPr txBox="1"/>
          <p:nvPr/>
        </p:nvSpPr>
        <p:spPr>
          <a:xfrm>
            <a:off x="1943841" y="3119806"/>
            <a:ext cx="81032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800" b="1" i="1" kern="0">
                <a:latin typeface="Calibri" panose="020F0502020204030204" pitchFamily="34" charset="0"/>
                <a:cs typeface="Arial" panose="020B0604020202020204" pitchFamily="34" charset="0"/>
              </a:defRPr>
            </a:lvl1pPr>
          </a:lstStyle>
          <a:p>
            <a:r>
              <a:rPr lang="it-IT" sz="1200" i="0" err="1"/>
              <a:t>Redolens</a:t>
            </a:r>
            <a:r>
              <a:rPr lang="it-IT" sz="1200" i="0"/>
              <a:t> </a:t>
            </a: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7EB583D1-125C-428F-BAF2-F52799C8D6CF}"/>
              </a:ext>
            </a:extLst>
          </p:cNvPr>
          <p:cNvSpPr txBox="1"/>
          <p:nvPr/>
        </p:nvSpPr>
        <p:spPr>
          <a:xfrm>
            <a:off x="1324362" y="4427999"/>
            <a:ext cx="81032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800" b="1" i="1" kern="0">
                <a:latin typeface="Calibri" panose="020F0502020204030204" pitchFamily="34" charset="0"/>
                <a:cs typeface="Arial" panose="020B0604020202020204" pitchFamily="34" charset="0"/>
              </a:defRPr>
            </a:lvl1pPr>
          </a:lstStyle>
          <a:p>
            <a:r>
              <a:rPr lang="it-IT" sz="1200" i="0" dirty="0" err="1"/>
              <a:t>Babinda</a:t>
            </a:r>
            <a:r>
              <a:rPr lang="it-IT" sz="1200" i="0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97785420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A357BB7-0598-7395-CFF6-8D32F4A41F9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magine 4">
            <a:extLst>
              <a:ext uri="{FF2B5EF4-FFF2-40B4-BE49-F238E27FC236}">
                <a16:creationId xmlns:a16="http://schemas.microsoft.com/office/drawing/2014/main" id="{5926EAF6-B025-E742-1F95-5EE851117DE9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5254" t="4644" r="1535" b="7872"/>
          <a:stretch>
            <a:fillRect/>
          </a:stretch>
        </p:blipFill>
        <p:spPr>
          <a:xfrm>
            <a:off x="569188" y="1305963"/>
            <a:ext cx="8767624" cy="4246075"/>
          </a:xfrm>
          <a:prstGeom prst="rect">
            <a:avLst/>
          </a:prstGeom>
        </p:spPr>
      </p:pic>
      <p:sp>
        <p:nvSpPr>
          <p:cNvPr id="2" name="CasellaDiTesto 1">
            <a:extLst>
              <a:ext uri="{FF2B5EF4-FFF2-40B4-BE49-F238E27FC236}">
                <a16:creationId xmlns:a16="http://schemas.microsoft.com/office/drawing/2014/main" id="{B2A2EC9A-F612-D2CA-A863-CD8054F1DA8D}"/>
              </a:ext>
            </a:extLst>
          </p:cNvPr>
          <p:cNvSpPr txBox="1"/>
          <p:nvPr/>
        </p:nvSpPr>
        <p:spPr>
          <a:xfrm>
            <a:off x="1410366" y="6434745"/>
            <a:ext cx="900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20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LST</a:t>
            </a:r>
          </a:p>
        </p:txBody>
      </p:sp>
      <p:sp>
        <p:nvSpPr>
          <p:cNvPr id="3" name="CasellaDiTesto 2">
            <a:extLst>
              <a:ext uri="{FF2B5EF4-FFF2-40B4-BE49-F238E27FC236}">
                <a16:creationId xmlns:a16="http://schemas.microsoft.com/office/drawing/2014/main" id="{731FA931-CEDC-79CB-7A9D-F8C9776E5D94}"/>
              </a:ext>
            </a:extLst>
          </p:cNvPr>
          <p:cNvSpPr txBox="1"/>
          <p:nvPr/>
        </p:nvSpPr>
        <p:spPr>
          <a:xfrm>
            <a:off x="7854235" y="6434745"/>
            <a:ext cx="900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20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WGS-</a:t>
            </a:r>
            <a:r>
              <a:rPr lang="it-IT" sz="120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ased</a:t>
            </a:r>
            <a:endParaRPr lang="it-IT" sz="120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15EEF25D-4E50-BDB9-35E4-8ED419246DF2}"/>
              </a:ext>
            </a:extLst>
          </p:cNvPr>
          <p:cNvSpPr txBox="1"/>
          <p:nvPr/>
        </p:nvSpPr>
        <p:spPr>
          <a:xfrm>
            <a:off x="0" y="201178"/>
            <a:ext cx="990600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1400" b="1" kern="0" dirty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The </a:t>
            </a:r>
            <a:r>
              <a:rPr lang="it-IT" sz="1400" b="1" i="1" kern="0" dirty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Fusarium </a:t>
            </a:r>
            <a:r>
              <a:rPr lang="it-IT" sz="1400" b="1" i="1" kern="0" dirty="0" err="1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nisikadoi</a:t>
            </a:r>
            <a:r>
              <a:rPr lang="it-IT" sz="1400" b="1" kern="0" dirty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it-IT" sz="1400" b="1" kern="0" dirty="0" err="1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species</a:t>
            </a:r>
            <a:r>
              <a:rPr lang="it-IT" sz="1400" b="1" kern="0" dirty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it-IT" sz="1400" b="1" kern="0" dirty="0" err="1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complex</a:t>
            </a:r>
            <a:endParaRPr lang="it-IT" sz="1400" b="1" i="1" kern="0" dirty="0">
              <a:solidFill>
                <a:schemeClr val="accent2">
                  <a:lumMod val="75000"/>
                </a:schemeClr>
              </a:solidFill>
              <a:latin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6222299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FD43FF3-2F88-91C2-F8F5-9A8269E356E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>
            <a:extLst>
              <a:ext uri="{FF2B5EF4-FFF2-40B4-BE49-F238E27FC236}">
                <a16:creationId xmlns:a16="http://schemas.microsoft.com/office/drawing/2014/main" id="{9B0A589F-605C-70E5-FE14-776391E5E7A2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8858" t="5823" r="10077" b="6427"/>
          <a:stretch>
            <a:fillRect/>
          </a:stretch>
        </p:blipFill>
        <p:spPr>
          <a:xfrm>
            <a:off x="39821" y="382209"/>
            <a:ext cx="9826359" cy="6308302"/>
          </a:xfrm>
          <a:prstGeom prst="rect">
            <a:avLst/>
          </a:prstGeom>
        </p:spPr>
      </p:pic>
      <p:sp>
        <p:nvSpPr>
          <p:cNvPr id="2" name="CasellaDiTesto 1">
            <a:extLst>
              <a:ext uri="{FF2B5EF4-FFF2-40B4-BE49-F238E27FC236}">
                <a16:creationId xmlns:a16="http://schemas.microsoft.com/office/drawing/2014/main" id="{7DBFBBD4-F643-8093-042E-342BB27256C3}"/>
              </a:ext>
            </a:extLst>
          </p:cNvPr>
          <p:cNvSpPr txBox="1"/>
          <p:nvPr/>
        </p:nvSpPr>
        <p:spPr>
          <a:xfrm>
            <a:off x="1410366" y="6493360"/>
            <a:ext cx="900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20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LST</a:t>
            </a:r>
          </a:p>
        </p:txBody>
      </p:sp>
      <p:sp>
        <p:nvSpPr>
          <p:cNvPr id="5" name="CasellaDiTesto 4">
            <a:extLst>
              <a:ext uri="{FF2B5EF4-FFF2-40B4-BE49-F238E27FC236}">
                <a16:creationId xmlns:a16="http://schemas.microsoft.com/office/drawing/2014/main" id="{95D61A1E-9A2F-50B8-8192-D8FF7481CE60}"/>
              </a:ext>
            </a:extLst>
          </p:cNvPr>
          <p:cNvSpPr txBox="1"/>
          <p:nvPr/>
        </p:nvSpPr>
        <p:spPr>
          <a:xfrm>
            <a:off x="7854235" y="6493360"/>
            <a:ext cx="900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20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WGS-</a:t>
            </a:r>
            <a:r>
              <a:rPr lang="it-IT" sz="120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ased</a:t>
            </a:r>
            <a:endParaRPr lang="it-IT" sz="120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08F7E8FC-0528-D469-1246-C4DB2FDDA888}"/>
              </a:ext>
            </a:extLst>
          </p:cNvPr>
          <p:cNvSpPr txBox="1"/>
          <p:nvPr/>
        </p:nvSpPr>
        <p:spPr>
          <a:xfrm>
            <a:off x="0" y="110644"/>
            <a:ext cx="990600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1400" b="1" kern="0" dirty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The </a:t>
            </a:r>
            <a:r>
              <a:rPr lang="it-IT" sz="1400" b="1" i="1" kern="0" dirty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Fusarium </a:t>
            </a:r>
            <a:r>
              <a:rPr lang="it-IT" sz="1400" b="1" i="1" kern="0" dirty="0" err="1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fujikuroi</a:t>
            </a:r>
            <a:r>
              <a:rPr lang="it-IT" sz="1400" b="1" kern="0" dirty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it-IT" sz="1400" b="1" kern="0" dirty="0" err="1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species</a:t>
            </a:r>
            <a:r>
              <a:rPr lang="it-IT" sz="1400" b="1" kern="0" dirty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it-IT" sz="1400" b="1" kern="0" dirty="0" err="1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complex</a:t>
            </a:r>
            <a:endParaRPr lang="it-IT" sz="1400" b="1" i="1" kern="0" dirty="0">
              <a:solidFill>
                <a:schemeClr val="accent2">
                  <a:lumMod val="75000"/>
                </a:schemeClr>
              </a:solidFill>
              <a:latin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55626053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2921123-4CF2-4D65-B0FD-9D65797FA3F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>
            <a:extLst>
              <a:ext uri="{FF2B5EF4-FFF2-40B4-BE49-F238E27FC236}">
                <a16:creationId xmlns:a16="http://schemas.microsoft.com/office/drawing/2014/main" id="{ABFC2799-3BD1-78BB-46D6-B73DC1FDF45E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006" t="6760" r="1260" b="8592"/>
          <a:stretch>
            <a:fillRect/>
          </a:stretch>
        </p:blipFill>
        <p:spPr>
          <a:xfrm>
            <a:off x="1316042" y="446786"/>
            <a:ext cx="7273916" cy="6128053"/>
          </a:xfrm>
          <a:prstGeom prst="rect">
            <a:avLst/>
          </a:prstGeom>
        </p:spPr>
      </p:pic>
      <p:sp>
        <p:nvSpPr>
          <p:cNvPr id="5" name="CasellaDiTesto 4">
            <a:extLst>
              <a:ext uri="{FF2B5EF4-FFF2-40B4-BE49-F238E27FC236}">
                <a16:creationId xmlns:a16="http://schemas.microsoft.com/office/drawing/2014/main" id="{E20BAB13-BF84-163D-A6E9-823B742EC7DE}"/>
              </a:ext>
            </a:extLst>
          </p:cNvPr>
          <p:cNvSpPr txBox="1"/>
          <p:nvPr/>
        </p:nvSpPr>
        <p:spPr>
          <a:xfrm>
            <a:off x="1410366" y="6574840"/>
            <a:ext cx="900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20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LST</a:t>
            </a:r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C70F5104-1080-AD6D-B920-FB02059AC622}"/>
              </a:ext>
            </a:extLst>
          </p:cNvPr>
          <p:cNvSpPr txBox="1"/>
          <p:nvPr/>
        </p:nvSpPr>
        <p:spPr>
          <a:xfrm>
            <a:off x="7854235" y="6574840"/>
            <a:ext cx="900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20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WGS-</a:t>
            </a:r>
            <a:r>
              <a:rPr lang="it-IT" sz="120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ased</a:t>
            </a:r>
            <a:endParaRPr lang="it-IT" sz="120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46D7B9C7-7F46-1F37-5272-6D28294CC58B}"/>
              </a:ext>
            </a:extLst>
          </p:cNvPr>
          <p:cNvSpPr txBox="1"/>
          <p:nvPr/>
        </p:nvSpPr>
        <p:spPr>
          <a:xfrm>
            <a:off x="0" y="74432"/>
            <a:ext cx="990600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1400" b="1" kern="0" dirty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The </a:t>
            </a:r>
            <a:r>
              <a:rPr lang="it-IT" sz="1400" b="1" i="1" kern="0" dirty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Fusarium </a:t>
            </a:r>
            <a:r>
              <a:rPr lang="it-IT" sz="1400" b="1" i="1" kern="0" dirty="0" err="1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oxysporum</a:t>
            </a:r>
            <a:r>
              <a:rPr lang="it-IT" sz="1400" b="1" i="1" kern="0" dirty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it-IT" sz="1400" b="1" kern="0" dirty="0" err="1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species</a:t>
            </a:r>
            <a:r>
              <a:rPr lang="it-IT" sz="1400" b="1" kern="0" dirty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it-IT" sz="1400" b="1" kern="0" dirty="0" err="1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complex</a:t>
            </a:r>
            <a:endParaRPr lang="it-IT" sz="1400" b="1" i="1" kern="0" dirty="0">
              <a:solidFill>
                <a:schemeClr val="accent2">
                  <a:lumMod val="75000"/>
                </a:schemeClr>
              </a:solidFill>
              <a:latin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369746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id="{A6624917-02EF-7AB5-E4F7-23D72C035A65}"/>
              </a:ext>
            </a:extLst>
          </p:cNvPr>
          <p:cNvSpPr txBox="1"/>
          <p:nvPr/>
        </p:nvSpPr>
        <p:spPr>
          <a:xfrm>
            <a:off x="1410366" y="6574840"/>
            <a:ext cx="900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20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LST</a:t>
            </a:r>
          </a:p>
        </p:txBody>
      </p:sp>
      <p:sp>
        <p:nvSpPr>
          <p:cNvPr id="3" name="CasellaDiTesto 2">
            <a:extLst>
              <a:ext uri="{FF2B5EF4-FFF2-40B4-BE49-F238E27FC236}">
                <a16:creationId xmlns:a16="http://schemas.microsoft.com/office/drawing/2014/main" id="{2617A59B-B8E4-90D2-433D-0ADF878E9A2D}"/>
              </a:ext>
            </a:extLst>
          </p:cNvPr>
          <p:cNvSpPr txBox="1"/>
          <p:nvPr/>
        </p:nvSpPr>
        <p:spPr>
          <a:xfrm>
            <a:off x="7854236" y="6574840"/>
            <a:ext cx="900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20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WGS-</a:t>
            </a:r>
            <a:r>
              <a:rPr lang="it-IT" sz="120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ased</a:t>
            </a:r>
            <a:endParaRPr lang="it-IT" sz="120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38" name="Gruppo 37">
            <a:extLst>
              <a:ext uri="{FF2B5EF4-FFF2-40B4-BE49-F238E27FC236}">
                <a16:creationId xmlns:a16="http://schemas.microsoft.com/office/drawing/2014/main" id="{F6EC2A27-CC65-42F8-937E-CE7D1FDE6DE5}"/>
              </a:ext>
            </a:extLst>
          </p:cNvPr>
          <p:cNvGrpSpPr/>
          <p:nvPr/>
        </p:nvGrpSpPr>
        <p:grpSpPr>
          <a:xfrm>
            <a:off x="0" y="38223"/>
            <a:ext cx="9831111" cy="6464682"/>
            <a:chOff x="0" y="38223"/>
            <a:chExt cx="9831111" cy="6464682"/>
          </a:xfrm>
        </p:grpSpPr>
        <p:pic>
          <p:nvPicPr>
            <p:cNvPr id="5" name="Immagine 4">
              <a:extLst>
                <a:ext uri="{FF2B5EF4-FFF2-40B4-BE49-F238E27FC236}">
                  <a16:creationId xmlns:a16="http://schemas.microsoft.com/office/drawing/2014/main" id="{4D14CE94-B980-4795-78DB-23D9EA97195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6417" t="7564" r="5028" b="9258"/>
            <a:stretch>
              <a:fillRect/>
            </a:stretch>
          </p:blipFill>
          <p:spPr>
            <a:xfrm>
              <a:off x="74889" y="676009"/>
              <a:ext cx="9756222" cy="5826896"/>
            </a:xfrm>
            <a:prstGeom prst="rect">
              <a:avLst/>
            </a:prstGeom>
          </p:spPr>
        </p:pic>
        <p:sp>
          <p:nvSpPr>
            <p:cNvPr id="31" name="CasellaDiTesto 30">
              <a:extLst>
                <a:ext uri="{FF2B5EF4-FFF2-40B4-BE49-F238E27FC236}">
                  <a16:creationId xmlns:a16="http://schemas.microsoft.com/office/drawing/2014/main" id="{C3EE8F81-4D26-0523-9313-9787C4490100}"/>
                </a:ext>
              </a:extLst>
            </p:cNvPr>
            <p:cNvSpPr txBox="1"/>
            <p:nvPr/>
          </p:nvSpPr>
          <p:spPr>
            <a:xfrm>
              <a:off x="0" y="38223"/>
              <a:ext cx="9831111" cy="52322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it-IT" sz="1400" b="1" kern="0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The</a:t>
              </a:r>
              <a:r>
                <a:rPr lang="it-IT" sz="1400" b="1" i="1" kern="0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 </a:t>
              </a:r>
              <a:r>
                <a:rPr lang="en-US" sz="1400" b="1" i="1" kern="0" err="1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Xenoacremonium</a:t>
              </a:r>
              <a:r>
                <a:rPr lang="en-US" sz="1400" b="1" i="1" kern="0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, </a:t>
              </a:r>
              <a:r>
                <a:rPr lang="en-US" sz="1400" b="1" i="1" kern="0" err="1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Stylonectria</a:t>
              </a:r>
              <a:r>
                <a:rPr lang="en-US" sz="1400" b="1" i="1" kern="0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, </a:t>
              </a:r>
              <a:r>
                <a:rPr lang="en-US" sz="1400" b="1" i="1" kern="0" err="1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Microcera</a:t>
              </a:r>
              <a:r>
                <a:rPr lang="en-US" sz="1400" b="1" i="1" kern="0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, </a:t>
              </a:r>
              <a:r>
                <a:rPr lang="en-US" sz="1400" b="1" i="1" kern="0" err="1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Pseudonectria</a:t>
              </a:r>
              <a:r>
                <a:rPr lang="en-US" sz="1400" b="1" i="1" kern="0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, Volutella, </a:t>
              </a:r>
              <a:r>
                <a:rPr lang="en-US" sz="1400" b="1" i="1" kern="0" err="1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Coccinonectria</a:t>
              </a:r>
              <a:r>
                <a:rPr lang="it-IT" sz="1400" b="1" i="1" kern="0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, </a:t>
              </a:r>
              <a:r>
                <a:rPr lang="en-US" sz="1400" b="1" i="1" kern="0" err="1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Corinectria</a:t>
              </a:r>
              <a:r>
                <a:rPr lang="it-IT" sz="1400" b="1" i="1" kern="0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, </a:t>
              </a:r>
              <a:r>
                <a:rPr lang="en-US" sz="1400" b="1" i="1" kern="0" err="1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Neonectria</a:t>
              </a:r>
              <a:r>
                <a:rPr lang="en-US" sz="1400" b="1" i="1" kern="0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, </a:t>
              </a:r>
              <a:r>
                <a:rPr lang="en-US" sz="1400" b="1" i="1" kern="0" err="1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Dactylonectria</a:t>
              </a:r>
              <a:r>
                <a:rPr lang="en-US" sz="1400" b="1" i="1" kern="0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, </a:t>
              </a:r>
              <a:r>
                <a:rPr lang="en-US" sz="1400" b="1" i="1" kern="0" err="1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Cylindrodendrum</a:t>
              </a:r>
              <a:r>
                <a:rPr lang="it-IT" sz="1400" b="1" i="1" kern="0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, </a:t>
              </a:r>
              <a:r>
                <a:rPr lang="en-US" sz="1400" b="1" i="1" kern="0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Ilyonectria, </a:t>
              </a:r>
              <a:r>
                <a:rPr lang="en-US" sz="1400" b="1" i="1" kern="0" err="1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Rugonectria</a:t>
              </a:r>
              <a:r>
                <a:rPr lang="en-US" sz="1400" b="1" i="1" kern="0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, </a:t>
              </a:r>
              <a:r>
                <a:rPr lang="en-US" sz="1400" b="1" i="1" kern="0" err="1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Mariannaea</a:t>
              </a:r>
              <a:r>
                <a:rPr lang="en-US" sz="1400" b="1" i="1" kern="0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, </a:t>
              </a:r>
              <a:r>
                <a:rPr lang="en-US" sz="1400" b="1" i="1" kern="0" err="1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Thelonectria</a:t>
              </a:r>
              <a:r>
                <a:rPr lang="en-US" sz="1400" b="1" i="1" kern="0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, </a:t>
              </a:r>
              <a:r>
                <a:rPr lang="en-US" sz="1400" b="1" i="1" kern="0" err="1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Aquanectria</a:t>
              </a:r>
              <a:r>
                <a:rPr lang="en-US" sz="1400" b="1" i="1" kern="0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, </a:t>
              </a:r>
              <a:r>
                <a:rPr lang="en-US" sz="1400" b="1" kern="0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and</a:t>
              </a:r>
              <a:r>
                <a:rPr lang="en-US" sz="1400" b="1" i="1" kern="0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 </a:t>
              </a:r>
              <a:r>
                <a:rPr lang="en-US" sz="1400" b="1" i="1" kern="0" err="1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Calonectria</a:t>
              </a:r>
              <a:r>
                <a:rPr lang="en-US" sz="1400" b="1" i="1" kern="0">
                  <a:latin typeface="Calibri" panose="020F0502020204030204" pitchFamily="34" charset="0"/>
                  <a:cs typeface="Arial" panose="020B0604020202020204" pitchFamily="34" charset="0"/>
                </a:rPr>
                <a:t> </a:t>
              </a:r>
              <a:r>
                <a:rPr lang="en-US" sz="1400" b="1" kern="0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genera</a:t>
              </a:r>
              <a:r>
                <a:rPr lang="en-US" sz="1400" b="1" i="1" kern="0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  </a:t>
              </a:r>
              <a:r>
                <a:rPr lang="en-US" sz="1400" b="1" i="1" kern="0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 </a:t>
              </a:r>
              <a:r>
                <a:rPr lang="en-US" sz="1400" b="1" i="1" kern="0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 </a:t>
              </a:r>
              <a:endParaRPr lang="it-IT" sz="1400" b="1" i="1" kern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B267264B-7386-4869-FF18-B9AA9336EC6C}"/>
              </a:ext>
            </a:extLst>
          </p:cNvPr>
          <p:cNvSpPr txBox="1"/>
          <p:nvPr/>
        </p:nvSpPr>
        <p:spPr>
          <a:xfrm>
            <a:off x="1963029" y="615107"/>
            <a:ext cx="792530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it-IT" sz="800" b="1" i="1" kern="0" err="1">
                <a:latin typeface="Calibri" panose="020F0502020204030204" pitchFamily="34" charset="0"/>
                <a:cs typeface="Arial" panose="020B0604020202020204" pitchFamily="34" charset="0"/>
              </a:rPr>
              <a:t>Mariannaea</a:t>
            </a:r>
            <a:endParaRPr lang="it-IT" sz="800" b="1" i="1" kern="0">
              <a:latin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EF99B88F-79DD-EAA1-2FEB-2FAA1D0B81B8}"/>
              </a:ext>
            </a:extLst>
          </p:cNvPr>
          <p:cNvSpPr txBox="1"/>
          <p:nvPr/>
        </p:nvSpPr>
        <p:spPr>
          <a:xfrm>
            <a:off x="2310366" y="752476"/>
            <a:ext cx="792530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i="1" kern="0" err="1">
                <a:latin typeface="Calibri" panose="020F0502020204030204" pitchFamily="34" charset="0"/>
                <a:cs typeface="Arial" panose="020B0604020202020204" pitchFamily="34" charset="0"/>
              </a:rPr>
              <a:t>Rugonectria</a:t>
            </a:r>
            <a:endParaRPr lang="it-IT" sz="800" b="1" i="1" kern="0">
              <a:latin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475526E5-9E53-D782-43F0-8752C03756B8}"/>
              </a:ext>
            </a:extLst>
          </p:cNvPr>
          <p:cNvSpPr txBox="1"/>
          <p:nvPr/>
        </p:nvSpPr>
        <p:spPr>
          <a:xfrm>
            <a:off x="1860366" y="895231"/>
            <a:ext cx="792530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i="1" kern="0" err="1">
                <a:latin typeface="Calibri" panose="020F0502020204030204" pitchFamily="34" charset="0"/>
                <a:cs typeface="Arial" panose="020B0604020202020204" pitchFamily="34" charset="0"/>
              </a:rPr>
              <a:t>Thelonectria</a:t>
            </a:r>
            <a:endParaRPr lang="it-IT" sz="800" b="1" i="1" kern="0">
              <a:latin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FEA142F4-A9C5-C08D-5EEE-4907EC08E567}"/>
              </a:ext>
            </a:extLst>
          </p:cNvPr>
          <p:cNvSpPr txBox="1"/>
          <p:nvPr/>
        </p:nvSpPr>
        <p:spPr>
          <a:xfrm>
            <a:off x="1914101" y="1853413"/>
            <a:ext cx="792530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i="1" kern="0" err="1">
                <a:latin typeface="Calibri" panose="020F0502020204030204" pitchFamily="34" charset="0"/>
                <a:cs typeface="Arial" panose="020B0604020202020204" pitchFamily="34" charset="0"/>
              </a:rPr>
              <a:t>Calonectria</a:t>
            </a:r>
            <a:endParaRPr lang="it-IT" sz="800" b="1" i="1" kern="0">
              <a:latin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ED205733-0BA2-E386-4B26-249917EBE023}"/>
              </a:ext>
            </a:extLst>
          </p:cNvPr>
          <p:cNvSpPr txBox="1"/>
          <p:nvPr/>
        </p:nvSpPr>
        <p:spPr>
          <a:xfrm>
            <a:off x="2003588" y="3026095"/>
            <a:ext cx="792530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i="1" kern="0" err="1">
                <a:latin typeface="Calibri" panose="020F0502020204030204" pitchFamily="34" charset="0"/>
                <a:cs typeface="Arial" panose="020B0604020202020204" pitchFamily="34" charset="0"/>
              </a:rPr>
              <a:t>Aquanectria</a:t>
            </a:r>
            <a:endParaRPr lang="it-IT" sz="800" b="1" i="1" kern="0">
              <a:latin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043EA5B9-36E1-D184-1D82-CEC77071D5EA}"/>
              </a:ext>
            </a:extLst>
          </p:cNvPr>
          <p:cNvSpPr txBox="1"/>
          <p:nvPr/>
        </p:nvSpPr>
        <p:spPr>
          <a:xfrm>
            <a:off x="2231990" y="3156850"/>
            <a:ext cx="648059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i="1" kern="0" err="1">
                <a:latin typeface="Calibri" panose="020F0502020204030204" pitchFamily="34" charset="0"/>
                <a:cs typeface="Arial" panose="020B0604020202020204" pitchFamily="34" charset="0"/>
              </a:rPr>
              <a:t>Corinectria</a:t>
            </a:r>
            <a:endParaRPr lang="it-IT" sz="800"/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53F079EA-6CCD-2B54-0F04-303C8A43DD02}"/>
              </a:ext>
            </a:extLst>
          </p:cNvPr>
          <p:cNvSpPr txBox="1"/>
          <p:nvPr/>
        </p:nvSpPr>
        <p:spPr>
          <a:xfrm>
            <a:off x="1969249" y="3577018"/>
            <a:ext cx="648059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i="1" kern="0" err="1">
                <a:latin typeface="Calibri" panose="020F0502020204030204" pitchFamily="34" charset="0"/>
                <a:cs typeface="Arial" panose="020B0604020202020204" pitchFamily="34" charset="0"/>
              </a:rPr>
              <a:t>Neonectria</a:t>
            </a:r>
            <a:endParaRPr lang="it-IT" sz="800" b="1" i="1" kern="0">
              <a:latin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FBC2FC59-8FE9-1D87-B177-565CF3BE6644}"/>
              </a:ext>
            </a:extLst>
          </p:cNvPr>
          <p:cNvSpPr txBox="1"/>
          <p:nvPr/>
        </p:nvSpPr>
        <p:spPr>
          <a:xfrm>
            <a:off x="2035264" y="4614433"/>
            <a:ext cx="648059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i="1" kern="0" err="1">
                <a:latin typeface="Calibri" panose="020F0502020204030204" pitchFamily="34" charset="0"/>
                <a:cs typeface="Arial" panose="020B0604020202020204" pitchFamily="34" charset="0"/>
              </a:rPr>
              <a:t>Ilyonectria</a:t>
            </a:r>
            <a:endParaRPr lang="it-IT" sz="800"/>
          </a:p>
        </p:txBody>
      </p:sp>
      <p:sp>
        <p:nvSpPr>
          <p:cNvPr id="25" name="CasellaDiTesto 24">
            <a:extLst>
              <a:ext uri="{FF2B5EF4-FFF2-40B4-BE49-F238E27FC236}">
                <a16:creationId xmlns:a16="http://schemas.microsoft.com/office/drawing/2014/main" id="{1909973D-9AFC-4832-375E-4ADA5A27A2FE}"/>
              </a:ext>
            </a:extLst>
          </p:cNvPr>
          <p:cNvSpPr txBox="1"/>
          <p:nvPr/>
        </p:nvSpPr>
        <p:spPr>
          <a:xfrm>
            <a:off x="1830192" y="5103835"/>
            <a:ext cx="925367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i="1" kern="0" err="1">
                <a:latin typeface="Calibri" panose="020F0502020204030204" pitchFamily="34" charset="0"/>
                <a:cs typeface="Arial" panose="020B0604020202020204" pitchFamily="34" charset="0"/>
              </a:rPr>
              <a:t>Cylindrodendrum</a:t>
            </a:r>
            <a:endParaRPr lang="it-IT" sz="800"/>
          </a:p>
        </p:txBody>
      </p:sp>
      <p:sp>
        <p:nvSpPr>
          <p:cNvPr id="26" name="CasellaDiTesto 25">
            <a:extLst>
              <a:ext uri="{FF2B5EF4-FFF2-40B4-BE49-F238E27FC236}">
                <a16:creationId xmlns:a16="http://schemas.microsoft.com/office/drawing/2014/main" id="{54EB921B-A5FF-DE64-C08B-A73513E5DB4F}"/>
              </a:ext>
            </a:extLst>
          </p:cNvPr>
          <p:cNvSpPr txBox="1"/>
          <p:nvPr/>
        </p:nvSpPr>
        <p:spPr>
          <a:xfrm>
            <a:off x="1963029" y="5247523"/>
            <a:ext cx="925367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i="1" kern="0" err="1">
                <a:latin typeface="Calibri" panose="020F0502020204030204" pitchFamily="34" charset="0"/>
                <a:cs typeface="Arial" panose="020B0604020202020204" pitchFamily="34" charset="0"/>
              </a:rPr>
              <a:t>Dactylonectria</a:t>
            </a:r>
            <a:endParaRPr lang="it-IT" sz="800"/>
          </a:p>
        </p:txBody>
      </p:sp>
      <p:sp>
        <p:nvSpPr>
          <p:cNvPr id="27" name="CasellaDiTesto 26">
            <a:extLst>
              <a:ext uri="{FF2B5EF4-FFF2-40B4-BE49-F238E27FC236}">
                <a16:creationId xmlns:a16="http://schemas.microsoft.com/office/drawing/2014/main" id="{FCF69CF8-210A-9F15-69EF-ED227292F2BA}"/>
              </a:ext>
            </a:extLst>
          </p:cNvPr>
          <p:cNvSpPr txBox="1"/>
          <p:nvPr/>
        </p:nvSpPr>
        <p:spPr>
          <a:xfrm>
            <a:off x="1954682" y="5536309"/>
            <a:ext cx="925367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i="1" kern="0" err="1">
                <a:latin typeface="Calibri" panose="020F0502020204030204" pitchFamily="34" charset="0"/>
                <a:cs typeface="Arial" panose="020B0604020202020204" pitchFamily="34" charset="0"/>
              </a:rPr>
              <a:t>Coccinonectria</a:t>
            </a:r>
            <a:endParaRPr lang="it-IT" sz="800"/>
          </a:p>
        </p:txBody>
      </p:sp>
      <p:sp>
        <p:nvSpPr>
          <p:cNvPr id="28" name="CasellaDiTesto 27">
            <a:extLst>
              <a:ext uri="{FF2B5EF4-FFF2-40B4-BE49-F238E27FC236}">
                <a16:creationId xmlns:a16="http://schemas.microsoft.com/office/drawing/2014/main" id="{222ADBA0-D2F5-F156-797F-DCE69953279C}"/>
              </a:ext>
            </a:extLst>
          </p:cNvPr>
          <p:cNvSpPr txBox="1"/>
          <p:nvPr/>
        </p:nvSpPr>
        <p:spPr>
          <a:xfrm>
            <a:off x="2107082" y="5676269"/>
            <a:ext cx="925367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i="1" kern="0">
                <a:latin typeface="Calibri" panose="020F0502020204030204" pitchFamily="34" charset="0"/>
                <a:cs typeface="Arial" panose="020B0604020202020204" pitchFamily="34" charset="0"/>
              </a:rPr>
              <a:t>Volutella</a:t>
            </a:r>
            <a:endParaRPr lang="it-IT" sz="800"/>
          </a:p>
        </p:txBody>
      </p:sp>
      <p:sp>
        <p:nvSpPr>
          <p:cNvPr id="29" name="CasellaDiTesto 28">
            <a:extLst>
              <a:ext uri="{FF2B5EF4-FFF2-40B4-BE49-F238E27FC236}">
                <a16:creationId xmlns:a16="http://schemas.microsoft.com/office/drawing/2014/main" id="{8D2046A4-0D03-DAC5-BB81-754E189665E2}"/>
              </a:ext>
            </a:extLst>
          </p:cNvPr>
          <p:cNvSpPr txBox="1"/>
          <p:nvPr/>
        </p:nvSpPr>
        <p:spPr>
          <a:xfrm>
            <a:off x="468964" y="6215707"/>
            <a:ext cx="993791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i="1" kern="0" err="1">
                <a:latin typeface="Calibri" panose="020F0502020204030204" pitchFamily="34" charset="0"/>
                <a:cs typeface="Arial" panose="020B0604020202020204" pitchFamily="34" charset="0"/>
              </a:rPr>
              <a:t>Xenoacremonium</a:t>
            </a:r>
            <a:endParaRPr lang="it-IT" sz="800"/>
          </a:p>
        </p:txBody>
      </p:sp>
      <p:sp>
        <p:nvSpPr>
          <p:cNvPr id="33" name="CasellaDiTesto 32">
            <a:extLst>
              <a:ext uri="{FF2B5EF4-FFF2-40B4-BE49-F238E27FC236}">
                <a16:creationId xmlns:a16="http://schemas.microsoft.com/office/drawing/2014/main" id="{48632D56-52A9-4A1D-5238-FF7D7D7A99BB}"/>
              </a:ext>
            </a:extLst>
          </p:cNvPr>
          <p:cNvSpPr txBox="1"/>
          <p:nvPr/>
        </p:nvSpPr>
        <p:spPr>
          <a:xfrm>
            <a:off x="1411669" y="5833537"/>
            <a:ext cx="820321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i="1" kern="0" err="1">
                <a:latin typeface="Calibri" panose="020F0502020204030204" pitchFamily="34" charset="0"/>
                <a:cs typeface="Arial" panose="020B0604020202020204" pitchFamily="34" charset="0"/>
              </a:rPr>
              <a:t>Pseudonectria</a:t>
            </a:r>
            <a:endParaRPr lang="it-IT" sz="800"/>
          </a:p>
        </p:txBody>
      </p:sp>
      <p:sp>
        <p:nvSpPr>
          <p:cNvPr id="34" name="CasellaDiTesto 33">
            <a:extLst>
              <a:ext uri="{FF2B5EF4-FFF2-40B4-BE49-F238E27FC236}">
                <a16:creationId xmlns:a16="http://schemas.microsoft.com/office/drawing/2014/main" id="{98DEDAE7-B208-E0C8-0376-05893D98B5BC}"/>
              </a:ext>
            </a:extLst>
          </p:cNvPr>
          <p:cNvSpPr txBox="1"/>
          <p:nvPr/>
        </p:nvSpPr>
        <p:spPr>
          <a:xfrm>
            <a:off x="1439064" y="5977226"/>
            <a:ext cx="713223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i="1" kern="0" err="1">
                <a:latin typeface="Calibri" panose="020F0502020204030204" pitchFamily="34" charset="0"/>
                <a:cs typeface="Arial" panose="020B0604020202020204" pitchFamily="34" charset="0"/>
              </a:rPr>
              <a:t>Stylonectria</a:t>
            </a:r>
            <a:endParaRPr lang="it-IT" sz="800"/>
          </a:p>
        </p:txBody>
      </p:sp>
      <p:sp>
        <p:nvSpPr>
          <p:cNvPr id="35" name="CasellaDiTesto 34">
            <a:extLst>
              <a:ext uri="{FF2B5EF4-FFF2-40B4-BE49-F238E27FC236}">
                <a16:creationId xmlns:a16="http://schemas.microsoft.com/office/drawing/2014/main" id="{4854ED95-4E38-2556-1AC5-F4C43E41EFF4}"/>
              </a:ext>
            </a:extLst>
          </p:cNvPr>
          <p:cNvSpPr txBox="1"/>
          <p:nvPr/>
        </p:nvSpPr>
        <p:spPr>
          <a:xfrm>
            <a:off x="1392972" y="6173553"/>
            <a:ext cx="713223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i="1" kern="0" err="1">
                <a:latin typeface="Calibri" panose="020F0502020204030204" pitchFamily="34" charset="0"/>
                <a:cs typeface="Arial" panose="020B0604020202020204" pitchFamily="34" charset="0"/>
              </a:rPr>
              <a:t>Microcera</a:t>
            </a:r>
            <a:endParaRPr lang="it-IT" sz="800"/>
          </a:p>
        </p:txBody>
      </p:sp>
      <p:graphicFrame>
        <p:nvGraphicFramePr>
          <p:cNvPr id="36" name="Tabella 35">
            <a:extLst>
              <a:ext uri="{FF2B5EF4-FFF2-40B4-BE49-F238E27FC236}">
                <a16:creationId xmlns:a16="http://schemas.microsoft.com/office/drawing/2014/main" id="{7DEA42D4-AAF8-672A-FC03-2B9ACD0742C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3127065"/>
              </p:ext>
            </p:extLst>
          </p:nvPr>
        </p:nvGraphicFramePr>
        <p:xfrm>
          <a:off x="1675403" y="6081978"/>
          <a:ext cx="713223" cy="200025"/>
        </p:xfrm>
        <a:graphic>
          <a:graphicData uri="http://schemas.openxmlformats.org/drawingml/2006/table">
            <a:tbl>
              <a:tblPr/>
              <a:tblGrid>
                <a:gridCol w="713223">
                  <a:extLst>
                    <a:ext uri="{9D8B030D-6E8A-4147-A177-3AD203B41FA5}">
                      <a16:colId xmlns:a16="http://schemas.microsoft.com/office/drawing/2014/main" val="1224110441"/>
                    </a:ext>
                  </a:extLst>
                </a:gridCol>
              </a:tblGrid>
              <a:tr h="200025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it-IT" sz="800" b="0" i="1" u="none" strike="noStrike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ectriaceae</a:t>
                      </a:r>
                      <a:r>
                        <a:rPr lang="it-IT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spp.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943793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689881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A66AC5C-8B37-24E3-2BCC-855DC7FAF68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>
            <a:extLst>
              <a:ext uri="{FF2B5EF4-FFF2-40B4-BE49-F238E27FC236}">
                <a16:creationId xmlns:a16="http://schemas.microsoft.com/office/drawing/2014/main" id="{241B01FC-84C9-30C6-5008-3F3ED8F08FFF}"/>
              </a:ext>
            </a:extLst>
          </p:cNvPr>
          <p:cNvSpPr txBox="1"/>
          <p:nvPr/>
        </p:nvSpPr>
        <p:spPr>
          <a:xfrm>
            <a:off x="1410366" y="6429987"/>
            <a:ext cx="900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20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LST</a:t>
            </a:r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C211D0CC-287D-8A56-FA2D-3A122A702589}"/>
              </a:ext>
            </a:extLst>
          </p:cNvPr>
          <p:cNvSpPr txBox="1"/>
          <p:nvPr/>
        </p:nvSpPr>
        <p:spPr>
          <a:xfrm>
            <a:off x="7854235" y="6429987"/>
            <a:ext cx="900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20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WGS-</a:t>
            </a:r>
            <a:r>
              <a:rPr lang="it-IT" sz="120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ased</a:t>
            </a:r>
            <a:endParaRPr lang="it-IT" sz="120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9" name="Gruppo 8">
            <a:extLst>
              <a:ext uri="{FF2B5EF4-FFF2-40B4-BE49-F238E27FC236}">
                <a16:creationId xmlns:a16="http://schemas.microsoft.com/office/drawing/2014/main" id="{0FBAF361-7112-8357-8799-601A5056E2D5}"/>
              </a:ext>
            </a:extLst>
          </p:cNvPr>
          <p:cNvGrpSpPr/>
          <p:nvPr/>
        </p:nvGrpSpPr>
        <p:grpSpPr>
          <a:xfrm>
            <a:off x="0" y="259202"/>
            <a:ext cx="9906000" cy="5383932"/>
            <a:chOff x="0" y="259202"/>
            <a:chExt cx="9906000" cy="5383932"/>
          </a:xfrm>
        </p:grpSpPr>
        <p:pic>
          <p:nvPicPr>
            <p:cNvPr id="3" name="Immagine 2">
              <a:extLst>
                <a:ext uri="{FF2B5EF4-FFF2-40B4-BE49-F238E27FC236}">
                  <a16:creationId xmlns:a16="http://schemas.microsoft.com/office/drawing/2014/main" id="{25E56E03-7F22-B532-9D56-A159B2905A4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6224" t="4727" r="7893" b="6347"/>
            <a:stretch>
              <a:fillRect/>
            </a:stretch>
          </p:blipFill>
          <p:spPr>
            <a:xfrm>
              <a:off x="808731" y="1214866"/>
              <a:ext cx="8288539" cy="4428268"/>
            </a:xfrm>
            <a:prstGeom prst="rect">
              <a:avLst/>
            </a:prstGeom>
          </p:spPr>
        </p:pic>
        <p:sp>
          <p:nvSpPr>
            <p:cNvPr id="7" name="CasellaDiTesto 6">
              <a:extLst>
                <a:ext uri="{FF2B5EF4-FFF2-40B4-BE49-F238E27FC236}">
                  <a16:creationId xmlns:a16="http://schemas.microsoft.com/office/drawing/2014/main" id="{7F70DAA5-B524-AA11-8DF9-1F0AA2CCA3EA}"/>
                </a:ext>
              </a:extLst>
            </p:cNvPr>
            <p:cNvSpPr txBox="1"/>
            <p:nvPr/>
          </p:nvSpPr>
          <p:spPr>
            <a:xfrm>
              <a:off x="0" y="259202"/>
              <a:ext cx="9906000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it-IT" sz="1400" b="1" kern="0" dirty="0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The </a:t>
              </a:r>
              <a:r>
                <a:rPr lang="it-IT" sz="1400" b="1" i="1" kern="0" dirty="0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Fusarium </a:t>
              </a:r>
              <a:r>
                <a:rPr lang="it-IT" sz="1400" b="1" i="1" kern="0" dirty="0" err="1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dimerum</a:t>
              </a:r>
              <a:r>
                <a:rPr lang="it-IT" sz="1400" b="1" i="1" kern="0" dirty="0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 </a:t>
              </a:r>
              <a:r>
                <a:rPr lang="it-IT" sz="1400" b="1" kern="0" dirty="0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and </a:t>
              </a:r>
              <a:r>
                <a:rPr lang="it-IT" sz="1400" b="1" i="1" kern="0" dirty="0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Fusarium </a:t>
              </a:r>
              <a:r>
                <a:rPr lang="it-IT" sz="1400" b="1" i="1" kern="0" dirty="0" err="1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ventricosum</a:t>
              </a:r>
              <a:r>
                <a:rPr lang="it-IT" sz="1400" b="1" i="1" kern="0" dirty="0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 </a:t>
              </a:r>
              <a:r>
                <a:rPr lang="it-IT" sz="1400" b="1" kern="0" dirty="0" err="1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species</a:t>
              </a:r>
              <a:r>
                <a:rPr lang="it-IT" sz="1400" b="1" kern="0" dirty="0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 </a:t>
              </a:r>
              <a:r>
                <a:rPr lang="it-IT" sz="1400" b="1" kern="0" dirty="0" err="1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complexes</a:t>
              </a:r>
              <a:endParaRPr lang="it-IT" sz="1400" b="1" i="1" kern="0" dirty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CasellaDiTesto 3">
              <a:extLst>
                <a:ext uri="{FF2B5EF4-FFF2-40B4-BE49-F238E27FC236}">
                  <a16:creationId xmlns:a16="http://schemas.microsoft.com/office/drawing/2014/main" id="{D658F82A-5C12-3CB2-E7BB-BF945D7F1C73}"/>
                </a:ext>
              </a:extLst>
            </p:cNvPr>
            <p:cNvSpPr txBox="1"/>
            <p:nvPr/>
          </p:nvSpPr>
          <p:spPr>
            <a:xfrm>
              <a:off x="7919980" y="2408978"/>
              <a:ext cx="808316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>
              <a:defPPr>
                <a:defRPr lang="en-US"/>
              </a:defPPr>
              <a:lvl1pPr>
                <a:defRPr sz="800" b="1" i="1" kern="0">
                  <a:latin typeface="Calibri" panose="020F050202020403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it-IT" sz="1200" i="0" dirty="0" err="1"/>
                <a:t>Dimerum</a:t>
              </a:r>
              <a:r>
                <a:rPr lang="it-IT" sz="1200" i="0" dirty="0"/>
                <a:t> </a:t>
              </a:r>
            </a:p>
          </p:txBody>
        </p:sp>
        <p:sp>
          <p:nvSpPr>
            <p:cNvPr id="8" name="CasellaDiTesto 7">
              <a:extLst>
                <a:ext uri="{FF2B5EF4-FFF2-40B4-BE49-F238E27FC236}">
                  <a16:creationId xmlns:a16="http://schemas.microsoft.com/office/drawing/2014/main" id="{461DA178-B086-7CEE-2A26-B1FEE6AF1D08}"/>
                </a:ext>
              </a:extLst>
            </p:cNvPr>
            <p:cNvSpPr txBox="1"/>
            <p:nvPr/>
          </p:nvSpPr>
          <p:spPr>
            <a:xfrm>
              <a:off x="6426542" y="4620980"/>
              <a:ext cx="1024647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>
              <a:defPPr>
                <a:defRPr lang="en-US"/>
              </a:defPPr>
              <a:lvl1pPr>
                <a:defRPr sz="800" b="1" i="1" kern="0">
                  <a:latin typeface="Calibri" panose="020F050202020403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it-IT" sz="1200" i="0" dirty="0" err="1"/>
                <a:t>Ventricosum</a:t>
              </a:r>
              <a:endParaRPr lang="it-IT" sz="1200" i="0" dirty="0"/>
            </a:p>
          </p:txBody>
        </p:sp>
      </p:grpSp>
    </p:spTree>
    <p:extLst>
      <p:ext uri="{BB962C8B-B14F-4D97-AF65-F5344CB8AC3E}">
        <p14:creationId xmlns:p14="http://schemas.microsoft.com/office/powerpoint/2010/main" val="336878386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F61013E-8691-E6F4-8925-97C024C5DF6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id="{BDA92817-EC15-8B1A-47F5-1402E6CC49EA}"/>
              </a:ext>
            </a:extLst>
          </p:cNvPr>
          <p:cNvSpPr txBox="1"/>
          <p:nvPr/>
        </p:nvSpPr>
        <p:spPr>
          <a:xfrm>
            <a:off x="1410366" y="6429987"/>
            <a:ext cx="900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20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LST</a:t>
            </a:r>
          </a:p>
        </p:txBody>
      </p:sp>
      <p:sp>
        <p:nvSpPr>
          <p:cNvPr id="3" name="CasellaDiTesto 2">
            <a:extLst>
              <a:ext uri="{FF2B5EF4-FFF2-40B4-BE49-F238E27FC236}">
                <a16:creationId xmlns:a16="http://schemas.microsoft.com/office/drawing/2014/main" id="{D85D28BA-F6ED-40D4-01C7-DF6F40BA812C}"/>
              </a:ext>
            </a:extLst>
          </p:cNvPr>
          <p:cNvSpPr txBox="1"/>
          <p:nvPr/>
        </p:nvSpPr>
        <p:spPr>
          <a:xfrm>
            <a:off x="7854235" y="6429987"/>
            <a:ext cx="900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20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WGS-</a:t>
            </a:r>
            <a:r>
              <a:rPr lang="it-IT" sz="120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ased</a:t>
            </a:r>
            <a:endParaRPr lang="it-IT" sz="120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11" name="Gruppo 10">
            <a:extLst>
              <a:ext uri="{FF2B5EF4-FFF2-40B4-BE49-F238E27FC236}">
                <a16:creationId xmlns:a16="http://schemas.microsoft.com/office/drawing/2014/main" id="{65F2ED48-B7BB-90D4-73DD-9FB89A8E87B0}"/>
              </a:ext>
            </a:extLst>
          </p:cNvPr>
          <p:cNvGrpSpPr/>
          <p:nvPr/>
        </p:nvGrpSpPr>
        <p:grpSpPr>
          <a:xfrm>
            <a:off x="0" y="170302"/>
            <a:ext cx="9906000" cy="5768035"/>
            <a:chOff x="0" y="170302"/>
            <a:chExt cx="9906000" cy="5768035"/>
          </a:xfrm>
        </p:grpSpPr>
        <p:sp>
          <p:nvSpPr>
            <p:cNvPr id="4" name="CasellaDiTesto 3">
              <a:extLst>
                <a:ext uri="{FF2B5EF4-FFF2-40B4-BE49-F238E27FC236}">
                  <a16:creationId xmlns:a16="http://schemas.microsoft.com/office/drawing/2014/main" id="{0A27858C-D4D9-2AC0-148F-DC153E6F968A}"/>
                </a:ext>
              </a:extLst>
            </p:cNvPr>
            <p:cNvSpPr txBox="1"/>
            <p:nvPr/>
          </p:nvSpPr>
          <p:spPr>
            <a:xfrm>
              <a:off x="0" y="170302"/>
              <a:ext cx="9906000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it-IT" sz="1400" b="1" kern="0" dirty="0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The </a:t>
              </a:r>
              <a:r>
                <a:rPr lang="it-IT" sz="1400" b="1" i="1" kern="0" dirty="0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Fusarium </a:t>
              </a:r>
              <a:r>
                <a:rPr lang="it-IT" sz="1400" b="1" i="1" kern="0" dirty="0" err="1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albidum</a:t>
              </a:r>
              <a:r>
                <a:rPr lang="it-IT" sz="1400" b="1" i="1" kern="0" dirty="0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, Fusarium </a:t>
              </a:r>
              <a:r>
                <a:rPr lang="it-IT" sz="1400" b="1" i="1" kern="0" dirty="0" err="1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staphyleae</a:t>
              </a:r>
              <a:r>
                <a:rPr lang="it-IT" sz="1400" b="1" i="1" kern="0" dirty="0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, Fusarium </a:t>
              </a:r>
              <a:r>
                <a:rPr lang="it-IT" sz="1400" b="1" i="1" kern="0" dirty="0" err="1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buxicola</a:t>
              </a:r>
              <a:r>
                <a:rPr lang="it-IT" sz="1400" b="1" i="1" kern="0" dirty="0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, </a:t>
              </a:r>
              <a:r>
                <a:rPr lang="it-IT" sz="1400" b="1" kern="0" dirty="0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and </a:t>
              </a:r>
              <a:r>
                <a:rPr lang="it-IT" sz="1400" b="1" i="1" kern="0" dirty="0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Fusarium </a:t>
              </a:r>
              <a:r>
                <a:rPr lang="it-IT" sz="1400" b="1" i="1" kern="0" dirty="0" err="1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decemcellulare</a:t>
              </a:r>
              <a:r>
                <a:rPr lang="it-IT" sz="1400" b="1" i="1" kern="0" dirty="0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 </a:t>
              </a:r>
              <a:r>
                <a:rPr lang="it-IT" sz="1400" b="1" kern="0" dirty="0" err="1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species</a:t>
              </a:r>
              <a:r>
                <a:rPr lang="it-IT" sz="1400" b="1" kern="0" dirty="0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 </a:t>
              </a:r>
              <a:r>
                <a:rPr lang="it-IT" sz="1400" b="1" kern="0" dirty="0" err="1">
                  <a:solidFill>
                    <a:schemeClr val="accent2">
                      <a:lumMod val="75000"/>
                    </a:schemeClr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complexes</a:t>
              </a:r>
              <a:endParaRPr lang="it-IT" sz="1400" b="1" i="1" kern="0" dirty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0" name="Gruppo 9">
              <a:extLst>
                <a:ext uri="{FF2B5EF4-FFF2-40B4-BE49-F238E27FC236}">
                  <a16:creationId xmlns:a16="http://schemas.microsoft.com/office/drawing/2014/main" id="{61C69FE4-7925-5DC1-4522-6E1279A33D09}"/>
                </a:ext>
              </a:extLst>
            </p:cNvPr>
            <p:cNvGrpSpPr/>
            <p:nvPr/>
          </p:nvGrpSpPr>
          <p:grpSpPr>
            <a:xfrm>
              <a:off x="352894" y="919663"/>
              <a:ext cx="9408505" cy="5018674"/>
              <a:chOff x="352894" y="919663"/>
              <a:chExt cx="9408505" cy="5018674"/>
            </a:xfrm>
          </p:grpSpPr>
          <p:pic>
            <p:nvPicPr>
              <p:cNvPr id="5" name="Immagine 4">
                <a:extLst>
                  <a:ext uri="{FF2B5EF4-FFF2-40B4-BE49-F238E27FC236}">
                    <a16:creationId xmlns:a16="http://schemas.microsoft.com/office/drawing/2014/main" id="{0ED3327B-7FFD-4BAF-D69B-0B7E192B920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rcRect l="7748" t="6268" r="7458" b="6075"/>
              <a:stretch>
                <a:fillRect/>
              </a:stretch>
            </p:blipFill>
            <p:spPr>
              <a:xfrm>
                <a:off x="352894" y="919663"/>
                <a:ext cx="9408505" cy="5018674"/>
              </a:xfrm>
              <a:prstGeom prst="rect">
                <a:avLst/>
              </a:prstGeom>
            </p:spPr>
          </p:pic>
          <p:sp>
            <p:nvSpPr>
              <p:cNvPr id="6" name="CasellaDiTesto 5">
                <a:extLst>
                  <a:ext uri="{FF2B5EF4-FFF2-40B4-BE49-F238E27FC236}">
                    <a16:creationId xmlns:a16="http://schemas.microsoft.com/office/drawing/2014/main" id="{44D54461-6608-7C0C-35F4-0B65D6830877}"/>
                  </a:ext>
                </a:extLst>
              </p:cNvPr>
              <p:cNvSpPr txBox="1"/>
              <p:nvPr/>
            </p:nvSpPr>
            <p:spPr>
              <a:xfrm>
                <a:off x="1083666" y="4930403"/>
                <a:ext cx="970513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>
                <a:defPPr>
                  <a:defRPr lang="en-US"/>
                </a:defPPr>
                <a:lvl1pPr>
                  <a:defRPr sz="800" b="1" i="1" kern="0">
                    <a:latin typeface="Calibri" panose="020F050202020403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it-IT" sz="1200" i="0" err="1"/>
                  <a:t>Staphyleae</a:t>
                </a:r>
                <a:r>
                  <a:rPr lang="it-IT" sz="1200" i="0"/>
                  <a:t> </a:t>
                </a:r>
              </a:p>
            </p:txBody>
          </p:sp>
          <p:sp>
            <p:nvSpPr>
              <p:cNvPr id="7" name="CasellaDiTesto 6">
                <a:extLst>
                  <a:ext uri="{FF2B5EF4-FFF2-40B4-BE49-F238E27FC236}">
                    <a16:creationId xmlns:a16="http://schemas.microsoft.com/office/drawing/2014/main" id="{3D675AAE-8531-EC46-4498-30A06A42FB67}"/>
                  </a:ext>
                </a:extLst>
              </p:cNvPr>
              <p:cNvSpPr txBox="1"/>
              <p:nvPr/>
            </p:nvSpPr>
            <p:spPr>
              <a:xfrm>
                <a:off x="1135180" y="2142127"/>
                <a:ext cx="810320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>
                <a:defPPr>
                  <a:defRPr lang="en-US"/>
                </a:defPPr>
                <a:lvl1pPr>
                  <a:defRPr sz="800" b="1" i="1" kern="0">
                    <a:latin typeface="Calibri" panose="020F050202020403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it-IT" sz="1200" i="0" err="1"/>
                  <a:t>Buxicola</a:t>
                </a:r>
                <a:r>
                  <a:rPr lang="it-IT" sz="1200" i="0"/>
                  <a:t> </a:t>
                </a:r>
              </a:p>
            </p:txBody>
          </p:sp>
          <p:sp>
            <p:nvSpPr>
              <p:cNvPr id="8" name="CasellaDiTesto 7">
                <a:extLst>
                  <a:ext uri="{FF2B5EF4-FFF2-40B4-BE49-F238E27FC236}">
                    <a16:creationId xmlns:a16="http://schemas.microsoft.com/office/drawing/2014/main" id="{BCFD85A6-AEFB-0561-9A49-D83188CDD152}"/>
                  </a:ext>
                </a:extLst>
              </p:cNvPr>
              <p:cNvSpPr txBox="1"/>
              <p:nvPr/>
            </p:nvSpPr>
            <p:spPr>
              <a:xfrm>
                <a:off x="1841213" y="3204635"/>
                <a:ext cx="1202333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>
                <a:defPPr>
                  <a:defRPr lang="en-US"/>
                </a:defPPr>
                <a:lvl1pPr>
                  <a:defRPr sz="800" b="1" i="1" kern="0">
                    <a:latin typeface="Calibri" panose="020F050202020403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it-IT" sz="1200" i="0" err="1"/>
                  <a:t>Decemcellulare</a:t>
                </a:r>
                <a:endParaRPr lang="it-IT" sz="1200" i="0"/>
              </a:p>
            </p:txBody>
          </p:sp>
          <p:sp>
            <p:nvSpPr>
              <p:cNvPr id="9" name="CasellaDiTesto 8">
                <a:extLst>
                  <a:ext uri="{FF2B5EF4-FFF2-40B4-BE49-F238E27FC236}">
                    <a16:creationId xmlns:a16="http://schemas.microsoft.com/office/drawing/2014/main" id="{693DDB9E-08F8-6376-E35C-E49F6CDAAD46}"/>
                  </a:ext>
                </a:extLst>
              </p:cNvPr>
              <p:cNvSpPr txBox="1"/>
              <p:nvPr/>
            </p:nvSpPr>
            <p:spPr>
              <a:xfrm>
                <a:off x="1568922" y="1279243"/>
                <a:ext cx="810320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>
                <a:defPPr>
                  <a:defRPr lang="en-US"/>
                </a:defPPr>
                <a:lvl1pPr>
                  <a:defRPr sz="800" b="1" i="1" kern="0">
                    <a:latin typeface="Calibri" panose="020F050202020403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it-IT" sz="1200" i="0" err="1"/>
                  <a:t>Albidum</a:t>
                </a:r>
                <a:r>
                  <a:rPr lang="it-IT" sz="1200" i="0"/>
                  <a:t> 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53761198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F38BCAB-4ED0-1425-8FC5-97D0454DA23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magine 4">
            <a:extLst>
              <a:ext uri="{FF2B5EF4-FFF2-40B4-BE49-F238E27FC236}">
                <a16:creationId xmlns:a16="http://schemas.microsoft.com/office/drawing/2014/main" id="{52EDDE10-D274-34F9-5290-656E3BD29726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8742" t="6446" r="7593" b="9096"/>
          <a:stretch>
            <a:fillRect/>
          </a:stretch>
        </p:blipFill>
        <p:spPr>
          <a:xfrm>
            <a:off x="16719" y="488890"/>
            <a:ext cx="9872561" cy="5803268"/>
          </a:xfrm>
          <a:prstGeom prst="rect">
            <a:avLst/>
          </a:prstGeom>
        </p:spPr>
      </p:pic>
      <p:sp>
        <p:nvSpPr>
          <p:cNvPr id="2" name="CasellaDiTesto 1">
            <a:extLst>
              <a:ext uri="{FF2B5EF4-FFF2-40B4-BE49-F238E27FC236}">
                <a16:creationId xmlns:a16="http://schemas.microsoft.com/office/drawing/2014/main" id="{93FF606A-04D2-39CB-A61E-8906FD3842CB}"/>
              </a:ext>
            </a:extLst>
          </p:cNvPr>
          <p:cNvSpPr txBox="1"/>
          <p:nvPr/>
        </p:nvSpPr>
        <p:spPr>
          <a:xfrm>
            <a:off x="1410366" y="6466200"/>
            <a:ext cx="900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20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LST</a:t>
            </a:r>
          </a:p>
        </p:txBody>
      </p:sp>
      <p:sp>
        <p:nvSpPr>
          <p:cNvPr id="3" name="CasellaDiTesto 2">
            <a:extLst>
              <a:ext uri="{FF2B5EF4-FFF2-40B4-BE49-F238E27FC236}">
                <a16:creationId xmlns:a16="http://schemas.microsoft.com/office/drawing/2014/main" id="{C7B86C8A-BEFA-C428-0CEC-B67E0AD7A201}"/>
              </a:ext>
            </a:extLst>
          </p:cNvPr>
          <p:cNvSpPr txBox="1"/>
          <p:nvPr/>
        </p:nvSpPr>
        <p:spPr>
          <a:xfrm>
            <a:off x="7854235" y="6466200"/>
            <a:ext cx="900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20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WGS-</a:t>
            </a:r>
            <a:r>
              <a:rPr lang="it-IT" sz="120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ased</a:t>
            </a:r>
            <a:endParaRPr lang="it-IT" sz="120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3E64CDEE-36D1-C4EE-A713-6921CCBD9855}"/>
              </a:ext>
            </a:extLst>
          </p:cNvPr>
          <p:cNvSpPr txBox="1"/>
          <p:nvPr/>
        </p:nvSpPr>
        <p:spPr>
          <a:xfrm>
            <a:off x="0" y="174018"/>
            <a:ext cx="990600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1400" b="1" kern="0" dirty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The </a:t>
            </a:r>
            <a:r>
              <a:rPr lang="it-IT" sz="1400" b="1" i="1" kern="0" dirty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Fusarium solani</a:t>
            </a:r>
            <a:r>
              <a:rPr lang="it-IT" sz="1400" b="1" kern="0" dirty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it-IT" sz="1400" b="1" kern="0" dirty="0" err="1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species</a:t>
            </a:r>
            <a:r>
              <a:rPr lang="it-IT" sz="1400" b="1" kern="0" dirty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it-IT" sz="1400" b="1" kern="0" dirty="0" err="1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complex</a:t>
            </a:r>
            <a:endParaRPr lang="it-IT" sz="1400" b="1" i="1" kern="0" dirty="0">
              <a:solidFill>
                <a:schemeClr val="accent2">
                  <a:lumMod val="75000"/>
                </a:schemeClr>
              </a:solidFill>
              <a:latin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8899614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66ABB2D-760D-2D71-8F42-9CABF90F91F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magine 4">
            <a:extLst>
              <a:ext uri="{FF2B5EF4-FFF2-40B4-BE49-F238E27FC236}">
                <a16:creationId xmlns:a16="http://schemas.microsoft.com/office/drawing/2014/main" id="{360C401E-60A5-4F70-02B6-ABDDB1E589F3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7122" t="6827" r="8881" b="5652"/>
          <a:stretch>
            <a:fillRect/>
          </a:stretch>
        </p:blipFill>
        <p:spPr>
          <a:xfrm>
            <a:off x="306164" y="930701"/>
            <a:ext cx="9293673" cy="4996598"/>
          </a:xfrm>
          <a:prstGeom prst="rect">
            <a:avLst/>
          </a:prstGeom>
        </p:spPr>
      </p:pic>
      <p:sp>
        <p:nvSpPr>
          <p:cNvPr id="2" name="CasellaDiTesto 1">
            <a:extLst>
              <a:ext uri="{FF2B5EF4-FFF2-40B4-BE49-F238E27FC236}">
                <a16:creationId xmlns:a16="http://schemas.microsoft.com/office/drawing/2014/main" id="{5D417809-D547-6486-C352-503E9BF76566}"/>
              </a:ext>
            </a:extLst>
          </p:cNvPr>
          <p:cNvSpPr txBox="1"/>
          <p:nvPr/>
        </p:nvSpPr>
        <p:spPr>
          <a:xfrm>
            <a:off x="1410366" y="6429987"/>
            <a:ext cx="900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20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LST</a:t>
            </a:r>
          </a:p>
        </p:txBody>
      </p:sp>
      <p:sp>
        <p:nvSpPr>
          <p:cNvPr id="3" name="CasellaDiTesto 2">
            <a:extLst>
              <a:ext uri="{FF2B5EF4-FFF2-40B4-BE49-F238E27FC236}">
                <a16:creationId xmlns:a16="http://schemas.microsoft.com/office/drawing/2014/main" id="{2B34399B-C82C-DE99-2F6A-8BEC50F1877B}"/>
              </a:ext>
            </a:extLst>
          </p:cNvPr>
          <p:cNvSpPr txBox="1"/>
          <p:nvPr/>
        </p:nvSpPr>
        <p:spPr>
          <a:xfrm>
            <a:off x="7854235" y="6429987"/>
            <a:ext cx="900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20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WGS-</a:t>
            </a:r>
            <a:r>
              <a:rPr lang="it-IT" sz="120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ased</a:t>
            </a:r>
            <a:endParaRPr lang="it-IT" sz="120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A54AB530-3726-2A0B-9B9B-DC4350742947}"/>
              </a:ext>
            </a:extLst>
          </p:cNvPr>
          <p:cNvSpPr txBox="1"/>
          <p:nvPr/>
        </p:nvSpPr>
        <p:spPr>
          <a:xfrm>
            <a:off x="0" y="170302"/>
            <a:ext cx="990600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1400" b="1" kern="0" dirty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The </a:t>
            </a:r>
            <a:r>
              <a:rPr lang="it-IT" sz="1400" b="1" i="1" kern="0" dirty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Fusarium </a:t>
            </a:r>
            <a:r>
              <a:rPr lang="it-IT" sz="1400" b="1" i="1" kern="0" dirty="0" err="1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buharicum</a:t>
            </a:r>
            <a:r>
              <a:rPr lang="it-IT" sz="1400" b="1" i="1" kern="0" dirty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, Fusarium </a:t>
            </a:r>
            <a:r>
              <a:rPr lang="it-IT" sz="1400" b="1" i="1" kern="0" dirty="0" err="1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lateritium</a:t>
            </a:r>
            <a:r>
              <a:rPr lang="it-IT" sz="1400" b="1" i="1" kern="0" dirty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it-IT" sz="1400" b="1" kern="0" dirty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and</a:t>
            </a:r>
            <a:r>
              <a:rPr lang="it-IT" sz="1400" b="1" i="1" kern="0" dirty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 Fusarium </a:t>
            </a:r>
            <a:r>
              <a:rPr lang="it-IT" sz="1400" b="1" i="1" kern="0" dirty="0" err="1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torreyae</a:t>
            </a:r>
            <a:r>
              <a:rPr lang="it-IT" sz="1400" b="1" i="1" kern="0" dirty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it-IT" sz="1400" b="1" kern="0" dirty="0" err="1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species</a:t>
            </a:r>
            <a:r>
              <a:rPr lang="it-IT" sz="1400" b="1" kern="0" dirty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it-IT" sz="1400" b="1" kern="0" dirty="0" err="1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complexes</a:t>
            </a:r>
            <a:endParaRPr lang="it-IT" sz="1400" b="1" i="1" kern="0" dirty="0">
              <a:solidFill>
                <a:schemeClr val="accent2">
                  <a:lumMod val="75000"/>
                </a:schemeClr>
              </a:solidFill>
              <a:latin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1F91717B-4005-0F08-F16A-B6D36A664F97}"/>
              </a:ext>
            </a:extLst>
          </p:cNvPr>
          <p:cNvSpPr txBox="1"/>
          <p:nvPr/>
        </p:nvSpPr>
        <p:spPr>
          <a:xfrm>
            <a:off x="523564" y="4601992"/>
            <a:ext cx="88680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800" b="1" i="1" kern="0">
                <a:latin typeface="Calibri" panose="020F0502020204030204" pitchFamily="34" charset="0"/>
                <a:cs typeface="Arial" panose="020B0604020202020204" pitchFamily="34" charset="0"/>
              </a:defRPr>
            </a:lvl1pPr>
          </a:lstStyle>
          <a:p>
            <a:r>
              <a:rPr lang="it-IT" sz="1200" i="0" err="1"/>
              <a:t>Buharicum</a:t>
            </a:r>
            <a:r>
              <a:rPr lang="it-IT" sz="1200" i="0"/>
              <a:t> </a:t>
            </a: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046820EB-CF41-774B-BE99-1F0CBBD672BD}"/>
              </a:ext>
            </a:extLst>
          </p:cNvPr>
          <p:cNvSpPr txBox="1"/>
          <p:nvPr/>
        </p:nvSpPr>
        <p:spPr>
          <a:xfrm>
            <a:off x="1500046" y="2483417"/>
            <a:ext cx="81032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800" b="1" i="1" kern="0">
                <a:latin typeface="Calibri" panose="020F0502020204030204" pitchFamily="34" charset="0"/>
                <a:cs typeface="Arial" panose="020B0604020202020204" pitchFamily="34" charset="0"/>
              </a:defRPr>
            </a:lvl1pPr>
          </a:lstStyle>
          <a:p>
            <a:r>
              <a:rPr lang="it-IT" sz="1200" i="0" err="1"/>
              <a:t>Torreyae</a:t>
            </a:r>
            <a:r>
              <a:rPr lang="it-IT" sz="1200" i="0"/>
              <a:t> </a:t>
            </a:r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4D451ED7-FA4C-1FF5-0454-54F50A0A85F8}"/>
              </a:ext>
            </a:extLst>
          </p:cNvPr>
          <p:cNvSpPr txBox="1"/>
          <p:nvPr/>
        </p:nvSpPr>
        <p:spPr>
          <a:xfrm>
            <a:off x="966965" y="1296609"/>
            <a:ext cx="88680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800" b="1" i="1" kern="0">
                <a:latin typeface="Calibri" panose="020F0502020204030204" pitchFamily="34" charset="0"/>
                <a:cs typeface="Arial" panose="020B0604020202020204" pitchFamily="34" charset="0"/>
              </a:defRPr>
            </a:lvl1pPr>
          </a:lstStyle>
          <a:p>
            <a:r>
              <a:rPr lang="it-IT" sz="1200" i="0" dirty="0" err="1"/>
              <a:t>Lateritium</a:t>
            </a:r>
            <a:r>
              <a:rPr lang="it-IT" sz="1200" i="0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93889520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DED08A8-0A1F-5285-5D25-EBCAF141ED4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>
            <a:extLst>
              <a:ext uri="{FF2B5EF4-FFF2-40B4-BE49-F238E27FC236}">
                <a16:creationId xmlns:a16="http://schemas.microsoft.com/office/drawing/2014/main" id="{69333BAE-3636-C6AA-7EDA-D4DCA1476228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6984" t="4872" r="7185" b="5980"/>
          <a:stretch>
            <a:fillRect/>
          </a:stretch>
        </p:blipFill>
        <p:spPr>
          <a:xfrm>
            <a:off x="381905" y="979133"/>
            <a:ext cx="9142191" cy="4899734"/>
          </a:xfrm>
          <a:prstGeom prst="rect">
            <a:avLst/>
          </a:prstGeom>
        </p:spPr>
      </p:pic>
      <p:sp>
        <p:nvSpPr>
          <p:cNvPr id="2" name="CasellaDiTesto 1">
            <a:extLst>
              <a:ext uri="{FF2B5EF4-FFF2-40B4-BE49-F238E27FC236}">
                <a16:creationId xmlns:a16="http://schemas.microsoft.com/office/drawing/2014/main" id="{9A4A0037-54A9-B1AF-D299-5E973DAEAA64}"/>
              </a:ext>
            </a:extLst>
          </p:cNvPr>
          <p:cNvSpPr txBox="1"/>
          <p:nvPr/>
        </p:nvSpPr>
        <p:spPr>
          <a:xfrm>
            <a:off x="1410366" y="6429987"/>
            <a:ext cx="900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20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LST</a:t>
            </a:r>
          </a:p>
        </p:txBody>
      </p:sp>
      <p:sp>
        <p:nvSpPr>
          <p:cNvPr id="5" name="CasellaDiTesto 4">
            <a:extLst>
              <a:ext uri="{FF2B5EF4-FFF2-40B4-BE49-F238E27FC236}">
                <a16:creationId xmlns:a16="http://schemas.microsoft.com/office/drawing/2014/main" id="{8FFCAAEE-B39F-2E2D-7850-8D950C243482}"/>
              </a:ext>
            </a:extLst>
          </p:cNvPr>
          <p:cNvSpPr txBox="1"/>
          <p:nvPr/>
        </p:nvSpPr>
        <p:spPr>
          <a:xfrm>
            <a:off x="7854235" y="6429987"/>
            <a:ext cx="900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20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WGS-</a:t>
            </a:r>
            <a:r>
              <a:rPr lang="it-IT" sz="120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ased</a:t>
            </a:r>
            <a:endParaRPr lang="it-IT" sz="120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590787FD-AE7A-CA14-0E74-99B25D8241B4}"/>
              </a:ext>
            </a:extLst>
          </p:cNvPr>
          <p:cNvSpPr txBox="1"/>
          <p:nvPr/>
        </p:nvSpPr>
        <p:spPr>
          <a:xfrm>
            <a:off x="0" y="170302"/>
            <a:ext cx="990600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1400" b="1" kern="0" dirty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The </a:t>
            </a:r>
            <a:r>
              <a:rPr lang="it-IT" sz="1400" b="1" i="1" kern="0" dirty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Fusarium </a:t>
            </a:r>
            <a:r>
              <a:rPr lang="it-IT" sz="1400" b="1" i="1" kern="0" dirty="0" err="1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tricinctum</a:t>
            </a:r>
            <a:r>
              <a:rPr lang="it-IT" sz="1400" b="1" kern="0" dirty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it-IT" sz="1400" b="1" kern="0" dirty="0" err="1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species</a:t>
            </a:r>
            <a:r>
              <a:rPr lang="it-IT" sz="1400" b="1" kern="0" dirty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it-IT" sz="1400" b="1" kern="0" dirty="0" err="1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complex</a:t>
            </a:r>
            <a:endParaRPr lang="it-IT" sz="1400" b="1" i="1" kern="0" dirty="0">
              <a:solidFill>
                <a:schemeClr val="accent2">
                  <a:lumMod val="75000"/>
                </a:schemeClr>
              </a:solidFill>
              <a:latin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0127455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6C7DC87-43FE-7983-D1D6-B724B0C93E4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magine 4">
            <a:extLst>
              <a:ext uri="{FF2B5EF4-FFF2-40B4-BE49-F238E27FC236}">
                <a16:creationId xmlns:a16="http://schemas.microsoft.com/office/drawing/2014/main" id="{5D4FF118-B53F-1358-BC58-0FD9CB63E682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7894" t="5416" r="6495" b="7192"/>
          <a:stretch>
            <a:fillRect/>
          </a:stretch>
        </p:blipFill>
        <p:spPr>
          <a:xfrm>
            <a:off x="288572" y="972152"/>
            <a:ext cx="9328856" cy="4913696"/>
          </a:xfrm>
          <a:prstGeom prst="rect">
            <a:avLst/>
          </a:prstGeom>
        </p:spPr>
      </p:pic>
      <p:sp>
        <p:nvSpPr>
          <p:cNvPr id="2" name="CasellaDiTesto 1">
            <a:extLst>
              <a:ext uri="{FF2B5EF4-FFF2-40B4-BE49-F238E27FC236}">
                <a16:creationId xmlns:a16="http://schemas.microsoft.com/office/drawing/2014/main" id="{55303DFC-179E-4E7E-A0F2-30CB5AE96174}"/>
              </a:ext>
            </a:extLst>
          </p:cNvPr>
          <p:cNvSpPr txBox="1"/>
          <p:nvPr/>
        </p:nvSpPr>
        <p:spPr>
          <a:xfrm>
            <a:off x="1410366" y="6357560"/>
            <a:ext cx="900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20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LST</a:t>
            </a:r>
          </a:p>
        </p:txBody>
      </p:sp>
      <p:sp>
        <p:nvSpPr>
          <p:cNvPr id="3" name="CasellaDiTesto 2">
            <a:extLst>
              <a:ext uri="{FF2B5EF4-FFF2-40B4-BE49-F238E27FC236}">
                <a16:creationId xmlns:a16="http://schemas.microsoft.com/office/drawing/2014/main" id="{8ED362F1-40B9-A131-E79D-C9C0F4CF0C9F}"/>
              </a:ext>
            </a:extLst>
          </p:cNvPr>
          <p:cNvSpPr txBox="1"/>
          <p:nvPr/>
        </p:nvSpPr>
        <p:spPr>
          <a:xfrm>
            <a:off x="7854235" y="6357560"/>
            <a:ext cx="900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20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WGS-</a:t>
            </a:r>
            <a:r>
              <a:rPr lang="it-IT" sz="120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ased</a:t>
            </a:r>
            <a:endParaRPr lang="it-IT" sz="120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A878D843-DFD5-3FE1-73A9-417A0D4CC64B}"/>
              </a:ext>
            </a:extLst>
          </p:cNvPr>
          <p:cNvSpPr txBox="1"/>
          <p:nvPr/>
        </p:nvSpPr>
        <p:spPr>
          <a:xfrm>
            <a:off x="0" y="146856"/>
            <a:ext cx="990600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1400" b="1" kern="0" dirty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The </a:t>
            </a:r>
            <a:r>
              <a:rPr lang="it-IT" sz="1400" b="1" i="1" kern="0" dirty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Fusarium </a:t>
            </a:r>
            <a:r>
              <a:rPr lang="it-IT" sz="1400" b="1" i="1" kern="0" dirty="0" err="1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incarnatum</a:t>
            </a:r>
            <a:r>
              <a:rPr lang="it-IT" sz="1400" b="1" i="1" kern="0" dirty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-equiseti </a:t>
            </a:r>
            <a:r>
              <a:rPr lang="it-IT" sz="1400" b="1" kern="0" dirty="0" err="1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species</a:t>
            </a:r>
            <a:r>
              <a:rPr lang="it-IT" sz="1400" b="1" kern="0" dirty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it-IT" sz="1400" b="1" kern="0" dirty="0" err="1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complex</a:t>
            </a:r>
            <a:endParaRPr lang="it-IT" sz="1400" b="1" i="1" kern="0" dirty="0">
              <a:solidFill>
                <a:schemeClr val="accent2">
                  <a:lumMod val="75000"/>
                </a:schemeClr>
              </a:solidFill>
              <a:latin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2961801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6D6739B-3348-DBB3-CC33-F918C05CA58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>
            <a:extLst>
              <a:ext uri="{FF2B5EF4-FFF2-40B4-BE49-F238E27FC236}">
                <a16:creationId xmlns:a16="http://schemas.microsoft.com/office/drawing/2014/main" id="{C75CB726-912F-C914-6EA3-F94BB5971EEE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6167" t="7373" r="2442" b="3161"/>
          <a:stretch>
            <a:fillRect/>
          </a:stretch>
        </p:blipFill>
        <p:spPr>
          <a:xfrm>
            <a:off x="1081581" y="1473452"/>
            <a:ext cx="7742839" cy="3911097"/>
          </a:xfrm>
          <a:prstGeom prst="rect">
            <a:avLst/>
          </a:prstGeom>
        </p:spPr>
      </p:pic>
      <p:sp>
        <p:nvSpPr>
          <p:cNvPr id="2" name="CasellaDiTesto 1">
            <a:extLst>
              <a:ext uri="{FF2B5EF4-FFF2-40B4-BE49-F238E27FC236}">
                <a16:creationId xmlns:a16="http://schemas.microsoft.com/office/drawing/2014/main" id="{6408BE43-19CD-1408-ECA8-8611561861C6}"/>
              </a:ext>
            </a:extLst>
          </p:cNvPr>
          <p:cNvSpPr txBox="1"/>
          <p:nvPr/>
        </p:nvSpPr>
        <p:spPr>
          <a:xfrm>
            <a:off x="1410366" y="6285133"/>
            <a:ext cx="900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20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LST</a:t>
            </a:r>
          </a:p>
        </p:txBody>
      </p:sp>
      <p:sp>
        <p:nvSpPr>
          <p:cNvPr id="5" name="CasellaDiTesto 4">
            <a:extLst>
              <a:ext uri="{FF2B5EF4-FFF2-40B4-BE49-F238E27FC236}">
                <a16:creationId xmlns:a16="http://schemas.microsoft.com/office/drawing/2014/main" id="{60B4F36F-FA6F-3BD9-9EE9-7E2A2A811F80}"/>
              </a:ext>
            </a:extLst>
          </p:cNvPr>
          <p:cNvSpPr txBox="1"/>
          <p:nvPr/>
        </p:nvSpPr>
        <p:spPr>
          <a:xfrm>
            <a:off x="7854235" y="6285133"/>
            <a:ext cx="900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20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WGS-</a:t>
            </a:r>
            <a:r>
              <a:rPr lang="it-IT" sz="120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ased</a:t>
            </a:r>
            <a:endParaRPr lang="it-IT" sz="120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6CE2C82F-2B93-7458-F246-85148C701DED}"/>
              </a:ext>
            </a:extLst>
          </p:cNvPr>
          <p:cNvSpPr txBox="1"/>
          <p:nvPr/>
        </p:nvSpPr>
        <p:spPr>
          <a:xfrm>
            <a:off x="0" y="201174"/>
            <a:ext cx="990600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1400" b="1" kern="0" dirty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The </a:t>
            </a:r>
            <a:r>
              <a:rPr lang="it-IT" sz="1400" b="1" i="1" kern="0" dirty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Fusarium </a:t>
            </a:r>
            <a:r>
              <a:rPr lang="it-IT" sz="1400" b="1" i="1" kern="0" dirty="0" err="1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chlamydosporum</a:t>
            </a:r>
            <a:r>
              <a:rPr lang="it-IT" sz="1400" b="1" kern="0" dirty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it-IT" sz="1400" b="1" kern="0" dirty="0" err="1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species</a:t>
            </a:r>
            <a:r>
              <a:rPr lang="it-IT" sz="1400" b="1" kern="0" dirty="0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it-IT" sz="1400" b="1" kern="0" dirty="0" err="1">
                <a:solidFill>
                  <a:schemeClr val="accent2">
                    <a:lumMod val="75000"/>
                  </a:schemeClr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complex</a:t>
            </a:r>
            <a:endParaRPr lang="it-IT" sz="1400" b="1" i="1" kern="0" dirty="0">
              <a:solidFill>
                <a:schemeClr val="accent2">
                  <a:lumMod val="75000"/>
                </a:schemeClr>
              </a:solidFill>
              <a:latin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9467681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i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</TotalTime>
  <Words>332</Words>
  <Application>Microsoft Office PowerPoint</Application>
  <PresentationFormat>A4 (21x29,7 cm)</PresentationFormat>
  <Paragraphs>79</Paragraphs>
  <Slides>14</Slides>
  <Notes>3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5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4</vt:i4>
      </vt:variant>
    </vt:vector>
  </HeadingPairs>
  <TitlesOfParts>
    <vt:vector size="20" baseType="lpstr">
      <vt:lpstr>Aptos</vt:lpstr>
      <vt:lpstr>Aptos Display</vt:lpstr>
      <vt:lpstr>Arial</vt:lpstr>
      <vt:lpstr>Calibri</vt:lpstr>
      <vt:lpstr>Times New Roman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lessandra Villani</dc:creator>
  <cp:lastModifiedBy>Alessandra Villani</cp:lastModifiedBy>
  <cp:revision>2</cp:revision>
  <cp:lastPrinted>2025-11-03T09:13:24Z</cp:lastPrinted>
  <dcterms:created xsi:type="dcterms:W3CDTF">2025-05-15T15:42:24Z</dcterms:created>
  <dcterms:modified xsi:type="dcterms:W3CDTF">2025-12-11T21:31:35Z</dcterms:modified>
</cp:coreProperties>
</file>